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32" autoAdjust="0"/>
    <p:restoredTop sz="94660"/>
  </p:normalViewPr>
  <p:slideViewPr>
    <p:cSldViewPr snapToGrid="0">
      <p:cViewPr varScale="1">
        <p:scale>
          <a:sx n="89" d="100"/>
          <a:sy n="89" d="100"/>
        </p:scale>
        <p:origin x="20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FBD4D-0005-4207-91CB-5A8D313B3E38}" type="datetimeFigureOut">
              <a:rPr lang="de-DE" smtClean="0"/>
              <a:t>21.05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0145C-6609-471E-8566-B03BB301AA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264575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FBD4D-0005-4207-91CB-5A8D313B3E38}" type="datetimeFigureOut">
              <a:rPr lang="de-DE" smtClean="0"/>
              <a:t>21.05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0145C-6609-471E-8566-B03BB301AA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545537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FBD4D-0005-4207-91CB-5A8D313B3E38}" type="datetimeFigureOut">
              <a:rPr lang="de-DE" smtClean="0"/>
              <a:t>21.05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0145C-6609-471E-8566-B03BB301AA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92779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FBD4D-0005-4207-91CB-5A8D313B3E38}" type="datetimeFigureOut">
              <a:rPr lang="de-DE" smtClean="0"/>
              <a:t>21.05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0145C-6609-471E-8566-B03BB301AA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667564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FBD4D-0005-4207-91CB-5A8D313B3E38}" type="datetimeFigureOut">
              <a:rPr lang="de-DE" smtClean="0"/>
              <a:t>21.05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0145C-6609-471E-8566-B03BB301AA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667113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FBD4D-0005-4207-91CB-5A8D313B3E38}" type="datetimeFigureOut">
              <a:rPr lang="de-DE" smtClean="0"/>
              <a:t>21.05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0145C-6609-471E-8566-B03BB301AA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942089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FBD4D-0005-4207-91CB-5A8D313B3E38}" type="datetimeFigureOut">
              <a:rPr lang="de-DE" smtClean="0"/>
              <a:t>21.05.2019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0145C-6609-471E-8566-B03BB301AA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81303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FBD4D-0005-4207-91CB-5A8D313B3E38}" type="datetimeFigureOut">
              <a:rPr lang="de-DE" smtClean="0"/>
              <a:t>21.05.2019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0145C-6609-471E-8566-B03BB301AA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949180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FBD4D-0005-4207-91CB-5A8D313B3E38}" type="datetimeFigureOut">
              <a:rPr lang="de-DE" smtClean="0"/>
              <a:t>21.05.2019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0145C-6609-471E-8566-B03BB301AA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681165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FBD4D-0005-4207-91CB-5A8D313B3E38}" type="datetimeFigureOut">
              <a:rPr lang="de-DE" smtClean="0"/>
              <a:t>21.05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0145C-6609-471E-8566-B03BB301AA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963770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FBD4D-0005-4207-91CB-5A8D313B3E38}" type="datetimeFigureOut">
              <a:rPr lang="de-DE" smtClean="0"/>
              <a:t>21.05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0145C-6609-471E-8566-B03BB301AA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322010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2FBD4D-0005-4207-91CB-5A8D313B3E38}" type="datetimeFigureOut">
              <a:rPr lang="de-DE" smtClean="0"/>
              <a:t>21.05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80145C-6609-471E-8566-B03BB301AA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773192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Survstat@RKI2.0" TargetMode="Externa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hyperlink" Target="mailto:Survstat@RKI2.0" TargetMode="Externa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Grafik 3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635" y="334847"/>
            <a:ext cx="12098359" cy="5377049"/>
          </a:xfrm>
          <a:prstGeom prst="rect">
            <a:avLst/>
          </a:prstGeom>
        </p:spPr>
      </p:pic>
      <p:sp>
        <p:nvSpPr>
          <p:cNvPr id="15" name="Textfeld 14"/>
          <p:cNvSpPr txBox="1"/>
          <p:nvPr/>
        </p:nvSpPr>
        <p:spPr>
          <a:xfrm>
            <a:off x="0" y="6080177"/>
            <a:ext cx="1135916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Figure S1</a:t>
            </a:r>
            <a:r>
              <a:rPr lang="en-US" sz="1200" dirty="0" smtClean="0"/>
              <a:t>: TBE case numbers in all German federal states in the years 2001-2019</a:t>
            </a:r>
          </a:p>
          <a:p>
            <a:r>
              <a:rPr lang="en-US" sz="1200" dirty="0" smtClean="0"/>
              <a:t> All case numbers are displayed for each federal state with specific color for each respective year . The total case numbers 2001-2018 are indicated next to each stacked bar. </a:t>
            </a:r>
          </a:p>
          <a:p>
            <a:r>
              <a:rPr lang="en-US" sz="1200" dirty="0" smtClean="0"/>
              <a:t>The graph was created using </a:t>
            </a:r>
            <a:r>
              <a:rPr lang="en-US" sz="1200" dirty="0" smtClean="0">
                <a:hlinkClick r:id="rId3"/>
              </a:rPr>
              <a:t>Survstat@RKI2.0</a:t>
            </a:r>
            <a:r>
              <a:rPr lang="en-US" sz="1200" dirty="0"/>
              <a:t> (https://</a:t>
            </a:r>
            <a:r>
              <a:rPr lang="en-US" sz="1200" dirty="0" smtClean="0"/>
              <a:t>survstat.rki.de/Content/Query/Chart.aspx). Detailed case numbers can be found in table S1 </a:t>
            </a:r>
            <a:endParaRPr lang="en-US" sz="1200" dirty="0"/>
          </a:p>
        </p:txBody>
      </p:sp>
      <p:sp>
        <p:nvSpPr>
          <p:cNvPr id="3" name="Rechteck 2"/>
          <p:cNvSpPr/>
          <p:nvPr/>
        </p:nvSpPr>
        <p:spPr>
          <a:xfrm>
            <a:off x="9235665" y="4421655"/>
            <a:ext cx="64793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600" b="1" dirty="0" smtClean="0">
                <a:solidFill>
                  <a:srgbClr val="000000"/>
                </a:solidFill>
              </a:rPr>
              <a:t>2589</a:t>
            </a:r>
            <a:r>
              <a:rPr lang="de-DE" sz="1600" b="1" dirty="0" smtClean="0"/>
              <a:t> </a:t>
            </a:r>
            <a:endParaRPr lang="de-DE" sz="1600" b="1" dirty="0"/>
          </a:p>
        </p:txBody>
      </p:sp>
      <p:sp>
        <p:nvSpPr>
          <p:cNvPr id="16" name="Rechteck 15"/>
          <p:cNvSpPr/>
          <p:nvPr/>
        </p:nvSpPr>
        <p:spPr>
          <a:xfrm>
            <a:off x="9235665" y="4198075"/>
            <a:ext cx="64793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600" b="1" dirty="0" smtClean="0">
                <a:solidFill>
                  <a:srgbClr val="000000"/>
                </a:solidFill>
              </a:rPr>
              <a:t>2581</a:t>
            </a:r>
            <a:r>
              <a:rPr lang="de-DE" sz="1600" b="1" dirty="0" smtClean="0"/>
              <a:t> </a:t>
            </a:r>
            <a:endParaRPr lang="de-DE" sz="1600" b="1" dirty="0"/>
          </a:p>
        </p:txBody>
      </p:sp>
      <p:grpSp>
        <p:nvGrpSpPr>
          <p:cNvPr id="21" name="Gruppieren 20"/>
          <p:cNvGrpSpPr/>
          <p:nvPr/>
        </p:nvGrpSpPr>
        <p:grpSpPr>
          <a:xfrm>
            <a:off x="3416963" y="3348405"/>
            <a:ext cx="439544" cy="999675"/>
            <a:chOff x="3416963" y="3348405"/>
            <a:chExt cx="439544" cy="999675"/>
          </a:xfrm>
        </p:grpSpPr>
        <p:sp>
          <p:nvSpPr>
            <p:cNvPr id="17" name="Rechteck 16"/>
            <p:cNvSpPr/>
            <p:nvPr/>
          </p:nvSpPr>
          <p:spPr>
            <a:xfrm>
              <a:off x="3416963" y="4009526"/>
              <a:ext cx="439544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600" b="1" dirty="0" smtClean="0">
                  <a:solidFill>
                    <a:srgbClr val="000000"/>
                  </a:solidFill>
                </a:rPr>
                <a:t>37</a:t>
              </a:r>
              <a:r>
                <a:rPr lang="de-DE" sz="1600" b="1" dirty="0" smtClean="0"/>
                <a:t> </a:t>
              </a:r>
              <a:endParaRPr lang="de-DE" sz="1600" b="1" dirty="0"/>
            </a:p>
          </p:txBody>
        </p:sp>
        <p:sp>
          <p:nvSpPr>
            <p:cNvPr id="18" name="Rechteck 17"/>
            <p:cNvSpPr/>
            <p:nvPr/>
          </p:nvSpPr>
          <p:spPr>
            <a:xfrm>
              <a:off x="3416963" y="3784860"/>
              <a:ext cx="439544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600" b="1" dirty="0" smtClean="0">
                  <a:solidFill>
                    <a:srgbClr val="000000"/>
                  </a:solidFill>
                </a:rPr>
                <a:t>30</a:t>
              </a:r>
              <a:r>
                <a:rPr lang="de-DE" sz="1600" b="1" dirty="0" smtClean="0"/>
                <a:t> </a:t>
              </a:r>
              <a:endParaRPr lang="de-DE" sz="1600" b="1" dirty="0"/>
            </a:p>
          </p:txBody>
        </p:sp>
        <p:sp>
          <p:nvSpPr>
            <p:cNvPr id="19" name="Rechteck 18"/>
            <p:cNvSpPr/>
            <p:nvPr/>
          </p:nvSpPr>
          <p:spPr>
            <a:xfrm>
              <a:off x="3416963" y="3560193"/>
              <a:ext cx="428322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600" b="1" dirty="0" smtClean="0">
                  <a:solidFill>
                    <a:srgbClr val="000000"/>
                  </a:solidFill>
                </a:rPr>
                <a:t>  1</a:t>
              </a:r>
              <a:r>
                <a:rPr lang="de-DE" sz="1600" b="1" dirty="0" smtClean="0"/>
                <a:t> </a:t>
              </a:r>
              <a:endParaRPr lang="de-DE" sz="1600" b="1" dirty="0"/>
            </a:p>
          </p:txBody>
        </p:sp>
        <p:sp>
          <p:nvSpPr>
            <p:cNvPr id="20" name="Rechteck 19"/>
            <p:cNvSpPr/>
            <p:nvPr/>
          </p:nvSpPr>
          <p:spPr>
            <a:xfrm>
              <a:off x="3416963" y="3348405"/>
              <a:ext cx="439544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600" b="1" dirty="0" smtClean="0">
                  <a:solidFill>
                    <a:srgbClr val="000000"/>
                  </a:solidFill>
                </a:rPr>
                <a:t>10</a:t>
              </a:r>
              <a:r>
                <a:rPr lang="de-DE" sz="1600" b="1" dirty="0" smtClean="0"/>
                <a:t> </a:t>
              </a:r>
              <a:endParaRPr lang="de-DE" sz="1600" b="1" dirty="0"/>
            </a:p>
          </p:txBody>
        </p:sp>
      </p:grpSp>
      <p:sp>
        <p:nvSpPr>
          <p:cNvPr id="22" name="Rechteck 21"/>
          <p:cNvSpPr/>
          <p:nvPr/>
        </p:nvSpPr>
        <p:spPr>
          <a:xfrm>
            <a:off x="4101691" y="3061367"/>
            <a:ext cx="54373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600" b="1" dirty="0" smtClean="0">
                <a:solidFill>
                  <a:srgbClr val="000000"/>
                </a:solidFill>
              </a:rPr>
              <a:t>346</a:t>
            </a:r>
            <a:r>
              <a:rPr lang="de-DE" sz="1600" b="1" dirty="0" smtClean="0"/>
              <a:t> </a:t>
            </a:r>
            <a:endParaRPr lang="de-DE" sz="1600" b="1" dirty="0"/>
          </a:p>
        </p:txBody>
      </p:sp>
      <p:grpSp>
        <p:nvGrpSpPr>
          <p:cNvPr id="23" name="Gruppieren 22"/>
          <p:cNvGrpSpPr/>
          <p:nvPr/>
        </p:nvGrpSpPr>
        <p:grpSpPr>
          <a:xfrm>
            <a:off x="3552434" y="2110573"/>
            <a:ext cx="439544" cy="1025433"/>
            <a:chOff x="3416963" y="3374163"/>
            <a:chExt cx="439544" cy="1025433"/>
          </a:xfrm>
        </p:grpSpPr>
        <p:sp>
          <p:nvSpPr>
            <p:cNvPr id="24" name="Rechteck 23"/>
            <p:cNvSpPr/>
            <p:nvPr/>
          </p:nvSpPr>
          <p:spPr>
            <a:xfrm>
              <a:off x="3416963" y="4061042"/>
              <a:ext cx="439544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600" b="1" dirty="0" smtClean="0">
                  <a:solidFill>
                    <a:srgbClr val="000000"/>
                  </a:solidFill>
                </a:rPr>
                <a:t>15</a:t>
              </a:r>
              <a:r>
                <a:rPr lang="de-DE" sz="1600" b="1" dirty="0" smtClean="0"/>
                <a:t> </a:t>
              </a:r>
              <a:endParaRPr lang="de-DE" sz="1600" b="1" dirty="0"/>
            </a:p>
          </p:txBody>
        </p:sp>
        <p:sp>
          <p:nvSpPr>
            <p:cNvPr id="25" name="Rechteck 24"/>
            <p:cNvSpPr/>
            <p:nvPr/>
          </p:nvSpPr>
          <p:spPr>
            <a:xfrm>
              <a:off x="3416963" y="3823497"/>
              <a:ext cx="439544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600" b="1" dirty="0" smtClean="0">
                  <a:solidFill>
                    <a:srgbClr val="000000"/>
                  </a:solidFill>
                </a:rPr>
                <a:t>61</a:t>
              </a:r>
              <a:r>
                <a:rPr lang="de-DE" sz="1600" b="1" dirty="0" smtClean="0"/>
                <a:t> </a:t>
              </a:r>
              <a:endParaRPr lang="de-DE" sz="1600" b="1" dirty="0"/>
            </a:p>
          </p:txBody>
        </p:sp>
        <p:sp>
          <p:nvSpPr>
            <p:cNvPr id="26" name="Rechteck 25"/>
            <p:cNvSpPr/>
            <p:nvPr/>
          </p:nvSpPr>
          <p:spPr>
            <a:xfrm>
              <a:off x="3416963" y="3598830"/>
              <a:ext cx="393056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600" b="1" dirty="0" smtClean="0">
                  <a:solidFill>
                    <a:srgbClr val="000000"/>
                  </a:solidFill>
                </a:rPr>
                <a:t>79</a:t>
              </a:r>
              <a:endParaRPr lang="de-DE" sz="1600" b="1" dirty="0"/>
            </a:p>
          </p:txBody>
        </p:sp>
        <p:sp>
          <p:nvSpPr>
            <p:cNvPr id="27" name="Rechteck 26"/>
            <p:cNvSpPr/>
            <p:nvPr/>
          </p:nvSpPr>
          <p:spPr>
            <a:xfrm>
              <a:off x="3416963" y="3374163"/>
              <a:ext cx="439544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600" b="1" dirty="0" smtClean="0">
                  <a:solidFill>
                    <a:srgbClr val="000000"/>
                  </a:solidFill>
                </a:rPr>
                <a:t>67</a:t>
              </a:r>
              <a:r>
                <a:rPr lang="de-DE" sz="1600" b="1" dirty="0" smtClean="0"/>
                <a:t> </a:t>
              </a:r>
              <a:endParaRPr lang="de-DE" sz="1600" b="1" dirty="0"/>
            </a:p>
          </p:txBody>
        </p:sp>
      </p:grpSp>
      <p:grpSp>
        <p:nvGrpSpPr>
          <p:cNvPr id="28" name="Gruppieren 27"/>
          <p:cNvGrpSpPr/>
          <p:nvPr/>
        </p:nvGrpSpPr>
        <p:grpSpPr>
          <a:xfrm>
            <a:off x="3560300" y="1133355"/>
            <a:ext cx="543739" cy="1081547"/>
            <a:chOff x="3416963" y="3459738"/>
            <a:chExt cx="543739" cy="948239"/>
          </a:xfrm>
        </p:grpSpPr>
        <p:sp>
          <p:nvSpPr>
            <p:cNvPr id="29" name="Rechteck 28"/>
            <p:cNvSpPr/>
            <p:nvPr/>
          </p:nvSpPr>
          <p:spPr>
            <a:xfrm>
              <a:off x="3416963" y="4111151"/>
              <a:ext cx="439544" cy="29682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600" b="1" dirty="0" smtClean="0">
                  <a:solidFill>
                    <a:srgbClr val="000000"/>
                  </a:solidFill>
                </a:rPr>
                <a:t>16</a:t>
              </a:r>
              <a:r>
                <a:rPr lang="de-DE" sz="1600" b="1" dirty="0" smtClean="0"/>
                <a:t> </a:t>
              </a:r>
              <a:endParaRPr lang="de-DE" sz="1600" b="1" dirty="0"/>
            </a:p>
          </p:txBody>
        </p:sp>
        <p:sp>
          <p:nvSpPr>
            <p:cNvPr id="30" name="Rechteck 29"/>
            <p:cNvSpPr/>
            <p:nvPr/>
          </p:nvSpPr>
          <p:spPr>
            <a:xfrm>
              <a:off x="3416963" y="3886483"/>
              <a:ext cx="543739" cy="29682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600" b="1" dirty="0" smtClean="0">
                  <a:solidFill>
                    <a:srgbClr val="000000"/>
                  </a:solidFill>
                </a:rPr>
                <a:t>116</a:t>
              </a:r>
              <a:r>
                <a:rPr lang="de-DE" sz="1600" b="1" dirty="0" smtClean="0"/>
                <a:t> </a:t>
              </a:r>
              <a:endParaRPr lang="de-DE" sz="1600" b="1" dirty="0"/>
            </a:p>
          </p:txBody>
        </p:sp>
        <p:sp>
          <p:nvSpPr>
            <p:cNvPr id="31" name="Rechteck 30"/>
            <p:cNvSpPr/>
            <p:nvPr/>
          </p:nvSpPr>
          <p:spPr>
            <a:xfrm>
              <a:off x="3416963" y="3661817"/>
              <a:ext cx="439544" cy="29682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600" b="1" dirty="0" smtClean="0">
                  <a:solidFill>
                    <a:srgbClr val="000000"/>
                  </a:solidFill>
                </a:rPr>
                <a:t>16</a:t>
              </a:r>
              <a:r>
                <a:rPr lang="de-DE" sz="1600" b="1" dirty="0" smtClean="0"/>
                <a:t> </a:t>
              </a:r>
              <a:endParaRPr lang="de-DE" sz="1600" b="1" dirty="0"/>
            </a:p>
          </p:txBody>
        </p:sp>
        <p:sp>
          <p:nvSpPr>
            <p:cNvPr id="32" name="Rechteck 31"/>
            <p:cNvSpPr/>
            <p:nvPr/>
          </p:nvSpPr>
          <p:spPr>
            <a:xfrm>
              <a:off x="3416963" y="3459738"/>
              <a:ext cx="439544" cy="29682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600" b="1" dirty="0" smtClean="0">
                  <a:solidFill>
                    <a:srgbClr val="000000"/>
                  </a:solidFill>
                </a:rPr>
                <a:t>15</a:t>
              </a:r>
              <a:r>
                <a:rPr lang="de-DE" sz="1600" b="1" dirty="0" smtClean="0"/>
                <a:t> </a:t>
              </a:r>
              <a:endParaRPr lang="de-DE" sz="1600" b="1" dirty="0"/>
            </a:p>
          </p:txBody>
        </p:sp>
      </p:grpSp>
      <p:sp>
        <p:nvSpPr>
          <p:cNvPr id="34" name="Rechteck 33"/>
          <p:cNvSpPr/>
          <p:nvPr/>
        </p:nvSpPr>
        <p:spPr>
          <a:xfrm>
            <a:off x="3565313" y="919395"/>
            <a:ext cx="43954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600" b="1" dirty="0" smtClean="0">
                <a:solidFill>
                  <a:srgbClr val="000000"/>
                </a:solidFill>
              </a:rPr>
              <a:t>82</a:t>
            </a:r>
            <a:r>
              <a:rPr lang="de-DE" sz="1600" b="1" dirty="0" smtClean="0"/>
              <a:t> </a:t>
            </a:r>
            <a:endParaRPr lang="de-DE" sz="1600" b="1" dirty="0"/>
          </a:p>
        </p:txBody>
      </p:sp>
    </p:spTree>
    <p:extLst>
      <p:ext uri="{BB962C8B-B14F-4D97-AF65-F5344CB8AC3E}">
        <p14:creationId xmlns:p14="http://schemas.microsoft.com/office/powerpoint/2010/main" val="10919138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uppieren 26"/>
          <p:cNvGrpSpPr/>
          <p:nvPr/>
        </p:nvGrpSpPr>
        <p:grpSpPr>
          <a:xfrm>
            <a:off x="1081240" y="128788"/>
            <a:ext cx="10029519" cy="6111027"/>
            <a:chOff x="1081240" y="746972"/>
            <a:chExt cx="10029519" cy="6111027"/>
          </a:xfrm>
        </p:grpSpPr>
        <p:pic>
          <p:nvPicPr>
            <p:cNvPr id="5" name="Grafik 4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892"/>
            <a:stretch/>
          </p:blipFill>
          <p:spPr>
            <a:xfrm>
              <a:off x="1081240" y="746972"/>
              <a:ext cx="10029519" cy="6111027"/>
            </a:xfrm>
            <a:prstGeom prst="rect">
              <a:avLst/>
            </a:prstGeom>
          </p:spPr>
        </p:pic>
        <p:sp>
          <p:nvSpPr>
            <p:cNvPr id="6" name="Ellipse 5"/>
            <p:cNvSpPr/>
            <p:nvPr/>
          </p:nvSpPr>
          <p:spPr>
            <a:xfrm>
              <a:off x="2169463" y="2856753"/>
              <a:ext cx="107577" cy="101600"/>
            </a:xfrm>
            <a:prstGeom prst="ellipse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7" name="Ellipse 6"/>
            <p:cNvSpPr/>
            <p:nvPr/>
          </p:nvSpPr>
          <p:spPr>
            <a:xfrm>
              <a:off x="1760075" y="2638609"/>
              <a:ext cx="107577" cy="101600"/>
            </a:xfrm>
            <a:prstGeom prst="ellipse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1482164" y="2407777"/>
              <a:ext cx="88197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auher</a:t>
              </a:r>
              <a:r>
                <a:rPr lang="de-D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Busch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Ellipse 9"/>
            <p:cNvSpPr/>
            <p:nvPr/>
          </p:nvSpPr>
          <p:spPr>
            <a:xfrm>
              <a:off x="4733370" y="3812986"/>
              <a:ext cx="107577" cy="101600"/>
            </a:xfrm>
            <a:prstGeom prst="ellipse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4497991" y="3592787"/>
              <a:ext cx="62388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Battaune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Ellipse 14"/>
            <p:cNvSpPr/>
            <p:nvPr/>
          </p:nvSpPr>
          <p:spPr>
            <a:xfrm>
              <a:off x="9649017" y="3531354"/>
              <a:ext cx="107577" cy="101600"/>
            </a:xfrm>
            <a:prstGeom prst="ellipse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6" name="Freihandform 15"/>
            <p:cNvSpPr/>
            <p:nvPr/>
          </p:nvSpPr>
          <p:spPr>
            <a:xfrm>
              <a:off x="3781425" y="2827426"/>
              <a:ext cx="6048375" cy="611099"/>
            </a:xfrm>
            <a:custGeom>
              <a:avLst/>
              <a:gdLst>
                <a:gd name="connsiteX0" fmla="*/ 6048375 w 6048375"/>
                <a:gd name="connsiteY0" fmla="*/ 611099 h 611099"/>
                <a:gd name="connsiteX1" fmla="*/ 6000750 w 6048375"/>
                <a:gd name="connsiteY1" fmla="*/ 582524 h 611099"/>
                <a:gd name="connsiteX2" fmla="*/ 5915025 w 6048375"/>
                <a:gd name="connsiteY2" fmla="*/ 563474 h 611099"/>
                <a:gd name="connsiteX3" fmla="*/ 5886450 w 6048375"/>
                <a:gd name="connsiteY3" fmla="*/ 544424 h 611099"/>
                <a:gd name="connsiteX4" fmla="*/ 5695950 w 6048375"/>
                <a:gd name="connsiteY4" fmla="*/ 515849 h 611099"/>
                <a:gd name="connsiteX5" fmla="*/ 5638800 w 6048375"/>
                <a:gd name="connsiteY5" fmla="*/ 458699 h 611099"/>
                <a:gd name="connsiteX6" fmla="*/ 5562600 w 6048375"/>
                <a:gd name="connsiteY6" fmla="*/ 439649 h 611099"/>
                <a:gd name="connsiteX7" fmla="*/ 5534025 w 6048375"/>
                <a:gd name="connsiteY7" fmla="*/ 420599 h 611099"/>
                <a:gd name="connsiteX8" fmla="*/ 5467350 w 6048375"/>
                <a:gd name="connsiteY8" fmla="*/ 401549 h 611099"/>
                <a:gd name="connsiteX9" fmla="*/ 5400675 w 6048375"/>
                <a:gd name="connsiteY9" fmla="*/ 372974 h 611099"/>
                <a:gd name="connsiteX10" fmla="*/ 5372100 w 6048375"/>
                <a:gd name="connsiteY10" fmla="*/ 353924 h 611099"/>
                <a:gd name="connsiteX11" fmla="*/ 5353050 w 6048375"/>
                <a:gd name="connsiteY11" fmla="*/ 325349 h 611099"/>
                <a:gd name="connsiteX12" fmla="*/ 5324475 w 6048375"/>
                <a:gd name="connsiteY12" fmla="*/ 315824 h 611099"/>
                <a:gd name="connsiteX13" fmla="*/ 5286375 w 6048375"/>
                <a:gd name="connsiteY13" fmla="*/ 296774 h 611099"/>
                <a:gd name="connsiteX14" fmla="*/ 5257800 w 6048375"/>
                <a:gd name="connsiteY14" fmla="*/ 277724 h 611099"/>
                <a:gd name="connsiteX15" fmla="*/ 5067300 w 6048375"/>
                <a:gd name="connsiteY15" fmla="*/ 258674 h 611099"/>
                <a:gd name="connsiteX16" fmla="*/ 4953000 w 6048375"/>
                <a:gd name="connsiteY16" fmla="*/ 249149 h 611099"/>
                <a:gd name="connsiteX17" fmla="*/ 4857750 w 6048375"/>
                <a:gd name="connsiteY17" fmla="*/ 230099 h 611099"/>
                <a:gd name="connsiteX18" fmla="*/ 4829175 w 6048375"/>
                <a:gd name="connsiteY18" fmla="*/ 211049 h 611099"/>
                <a:gd name="connsiteX19" fmla="*/ 4772025 w 6048375"/>
                <a:gd name="connsiteY19" fmla="*/ 201524 h 611099"/>
                <a:gd name="connsiteX20" fmla="*/ 4752975 w 6048375"/>
                <a:gd name="connsiteY20" fmla="*/ 172949 h 611099"/>
                <a:gd name="connsiteX21" fmla="*/ 4695825 w 6048375"/>
                <a:gd name="connsiteY21" fmla="*/ 134849 h 611099"/>
                <a:gd name="connsiteX22" fmla="*/ 4610100 w 6048375"/>
                <a:gd name="connsiteY22" fmla="*/ 106274 h 611099"/>
                <a:gd name="connsiteX23" fmla="*/ 4581525 w 6048375"/>
                <a:gd name="connsiteY23" fmla="*/ 96749 h 611099"/>
                <a:gd name="connsiteX24" fmla="*/ 4476750 w 6048375"/>
                <a:gd name="connsiteY24" fmla="*/ 87224 h 611099"/>
                <a:gd name="connsiteX25" fmla="*/ 4419600 w 6048375"/>
                <a:gd name="connsiteY25" fmla="*/ 68174 h 611099"/>
                <a:gd name="connsiteX26" fmla="*/ 4105275 w 6048375"/>
                <a:gd name="connsiteY26" fmla="*/ 49124 h 611099"/>
                <a:gd name="connsiteX27" fmla="*/ 4076700 w 6048375"/>
                <a:gd name="connsiteY27" fmla="*/ 39599 h 611099"/>
                <a:gd name="connsiteX28" fmla="*/ 3695700 w 6048375"/>
                <a:gd name="connsiteY28" fmla="*/ 20549 h 611099"/>
                <a:gd name="connsiteX29" fmla="*/ 3438525 w 6048375"/>
                <a:gd name="connsiteY29" fmla="*/ 20549 h 611099"/>
                <a:gd name="connsiteX30" fmla="*/ 3409950 w 6048375"/>
                <a:gd name="connsiteY30" fmla="*/ 39599 h 611099"/>
                <a:gd name="connsiteX31" fmla="*/ 3286125 w 6048375"/>
                <a:gd name="connsiteY31" fmla="*/ 58649 h 611099"/>
                <a:gd name="connsiteX32" fmla="*/ 3114675 w 6048375"/>
                <a:gd name="connsiteY32" fmla="*/ 87224 h 611099"/>
                <a:gd name="connsiteX33" fmla="*/ 2628900 w 6048375"/>
                <a:gd name="connsiteY33" fmla="*/ 87224 h 611099"/>
                <a:gd name="connsiteX34" fmla="*/ 2447925 w 6048375"/>
                <a:gd name="connsiteY34" fmla="*/ 68174 h 611099"/>
                <a:gd name="connsiteX35" fmla="*/ 2409825 w 6048375"/>
                <a:gd name="connsiteY35" fmla="*/ 58649 h 611099"/>
                <a:gd name="connsiteX36" fmla="*/ 2200275 w 6048375"/>
                <a:gd name="connsiteY36" fmla="*/ 39599 h 611099"/>
                <a:gd name="connsiteX37" fmla="*/ 1628775 w 6048375"/>
                <a:gd name="connsiteY37" fmla="*/ 58649 h 611099"/>
                <a:gd name="connsiteX38" fmla="*/ 1428750 w 6048375"/>
                <a:gd name="connsiteY38" fmla="*/ 77699 h 611099"/>
                <a:gd name="connsiteX39" fmla="*/ 1009650 w 6048375"/>
                <a:gd name="connsiteY39" fmla="*/ 87224 h 611099"/>
                <a:gd name="connsiteX40" fmla="*/ 933450 w 6048375"/>
                <a:gd name="connsiteY40" fmla="*/ 77699 h 611099"/>
                <a:gd name="connsiteX41" fmla="*/ 904875 w 6048375"/>
                <a:gd name="connsiteY41" fmla="*/ 68174 h 611099"/>
                <a:gd name="connsiteX42" fmla="*/ 866775 w 6048375"/>
                <a:gd name="connsiteY42" fmla="*/ 58649 h 611099"/>
                <a:gd name="connsiteX43" fmla="*/ 647700 w 6048375"/>
                <a:gd name="connsiteY43" fmla="*/ 68174 h 611099"/>
                <a:gd name="connsiteX44" fmla="*/ 619125 w 6048375"/>
                <a:gd name="connsiteY44" fmla="*/ 125324 h 611099"/>
                <a:gd name="connsiteX45" fmla="*/ 581025 w 6048375"/>
                <a:gd name="connsiteY45" fmla="*/ 144374 h 611099"/>
                <a:gd name="connsiteX46" fmla="*/ 390525 w 6048375"/>
                <a:gd name="connsiteY46" fmla="*/ 163424 h 611099"/>
                <a:gd name="connsiteX47" fmla="*/ 314325 w 6048375"/>
                <a:gd name="connsiteY47" fmla="*/ 182474 h 611099"/>
                <a:gd name="connsiteX48" fmla="*/ 238125 w 6048375"/>
                <a:gd name="connsiteY48" fmla="*/ 191999 h 611099"/>
                <a:gd name="connsiteX49" fmla="*/ 200025 w 6048375"/>
                <a:gd name="connsiteY49" fmla="*/ 201524 h 611099"/>
                <a:gd name="connsiteX50" fmla="*/ 161925 w 6048375"/>
                <a:gd name="connsiteY50" fmla="*/ 220574 h 611099"/>
                <a:gd name="connsiteX51" fmla="*/ 0 w 6048375"/>
                <a:gd name="connsiteY51" fmla="*/ 220574 h 6110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</a:cxnLst>
              <a:rect l="l" t="t" r="r" b="b"/>
              <a:pathLst>
                <a:path w="6048375" h="611099">
                  <a:moveTo>
                    <a:pt x="6048375" y="611099"/>
                  </a:moveTo>
                  <a:cubicBezTo>
                    <a:pt x="6032500" y="601574"/>
                    <a:pt x="6017309" y="590803"/>
                    <a:pt x="6000750" y="582524"/>
                  </a:cubicBezTo>
                  <a:cubicBezTo>
                    <a:pt x="5977302" y="570800"/>
                    <a:pt x="5936975" y="567132"/>
                    <a:pt x="5915025" y="563474"/>
                  </a:cubicBezTo>
                  <a:cubicBezTo>
                    <a:pt x="5905500" y="557124"/>
                    <a:pt x="5896689" y="549544"/>
                    <a:pt x="5886450" y="544424"/>
                  </a:cubicBezTo>
                  <a:cubicBezTo>
                    <a:pt x="5815725" y="509062"/>
                    <a:pt x="5796654" y="522563"/>
                    <a:pt x="5695950" y="515849"/>
                  </a:cubicBezTo>
                  <a:cubicBezTo>
                    <a:pt x="5676900" y="496799"/>
                    <a:pt x="5665218" y="463983"/>
                    <a:pt x="5638800" y="458699"/>
                  </a:cubicBezTo>
                  <a:cubicBezTo>
                    <a:pt x="5620686" y="455076"/>
                    <a:pt x="5582126" y="449412"/>
                    <a:pt x="5562600" y="439649"/>
                  </a:cubicBezTo>
                  <a:cubicBezTo>
                    <a:pt x="5552361" y="434529"/>
                    <a:pt x="5544264" y="425719"/>
                    <a:pt x="5534025" y="420599"/>
                  </a:cubicBezTo>
                  <a:cubicBezTo>
                    <a:pt x="5518800" y="412986"/>
                    <a:pt x="5481592" y="405618"/>
                    <a:pt x="5467350" y="401549"/>
                  </a:cubicBezTo>
                  <a:cubicBezTo>
                    <a:pt x="5440635" y="393916"/>
                    <a:pt x="5426075" y="387488"/>
                    <a:pt x="5400675" y="372974"/>
                  </a:cubicBezTo>
                  <a:cubicBezTo>
                    <a:pt x="5390736" y="367294"/>
                    <a:pt x="5381625" y="360274"/>
                    <a:pt x="5372100" y="353924"/>
                  </a:cubicBezTo>
                  <a:cubicBezTo>
                    <a:pt x="5365750" y="344399"/>
                    <a:pt x="5361989" y="332500"/>
                    <a:pt x="5353050" y="325349"/>
                  </a:cubicBezTo>
                  <a:cubicBezTo>
                    <a:pt x="5345210" y="319077"/>
                    <a:pt x="5333703" y="319779"/>
                    <a:pt x="5324475" y="315824"/>
                  </a:cubicBezTo>
                  <a:cubicBezTo>
                    <a:pt x="5311424" y="310231"/>
                    <a:pt x="5298703" y="303819"/>
                    <a:pt x="5286375" y="296774"/>
                  </a:cubicBezTo>
                  <a:cubicBezTo>
                    <a:pt x="5276436" y="291094"/>
                    <a:pt x="5268039" y="282844"/>
                    <a:pt x="5257800" y="277724"/>
                  </a:cubicBezTo>
                  <a:cubicBezTo>
                    <a:pt x="5208063" y="252855"/>
                    <a:pt x="5076986" y="259342"/>
                    <a:pt x="5067300" y="258674"/>
                  </a:cubicBezTo>
                  <a:cubicBezTo>
                    <a:pt x="5029159" y="256044"/>
                    <a:pt x="4990998" y="253371"/>
                    <a:pt x="4953000" y="249149"/>
                  </a:cubicBezTo>
                  <a:cubicBezTo>
                    <a:pt x="4910962" y="244478"/>
                    <a:pt x="4895590" y="239559"/>
                    <a:pt x="4857750" y="230099"/>
                  </a:cubicBezTo>
                  <a:cubicBezTo>
                    <a:pt x="4848225" y="223749"/>
                    <a:pt x="4840035" y="214669"/>
                    <a:pt x="4829175" y="211049"/>
                  </a:cubicBezTo>
                  <a:cubicBezTo>
                    <a:pt x="4810853" y="204942"/>
                    <a:pt x="4789299" y="210161"/>
                    <a:pt x="4772025" y="201524"/>
                  </a:cubicBezTo>
                  <a:cubicBezTo>
                    <a:pt x="4761786" y="196404"/>
                    <a:pt x="4761590" y="180487"/>
                    <a:pt x="4752975" y="172949"/>
                  </a:cubicBezTo>
                  <a:cubicBezTo>
                    <a:pt x="4735745" y="157872"/>
                    <a:pt x="4717545" y="142089"/>
                    <a:pt x="4695825" y="134849"/>
                  </a:cubicBezTo>
                  <a:lnTo>
                    <a:pt x="4610100" y="106274"/>
                  </a:lnTo>
                  <a:cubicBezTo>
                    <a:pt x="4600575" y="103099"/>
                    <a:pt x="4591524" y="97658"/>
                    <a:pt x="4581525" y="96749"/>
                  </a:cubicBezTo>
                  <a:lnTo>
                    <a:pt x="4476750" y="87224"/>
                  </a:lnTo>
                  <a:lnTo>
                    <a:pt x="4419600" y="68174"/>
                  </a:lnTo>
                  <a:cubicBezTo>
                    <a:pt x="4300613" y="28512"/>
                    <a:pt x="4401060" y="58983"/>
                    <a:pt x="4105275" y="49124"/>
                  </a:cubicBezTo>
                  <a:cubicBezTo>
                    <a:pt x="4095750" y="45949"/>
                    <a:pt x="4086501" y="41777"/>
                    <a:pt x="4076700" y="39599"/>
                  </a:cubicBezTo>
                  <a:cubicBezTo>
                    <a:pt x="3960184" y="13707"/>
                    <a:pt x="3775130" y="22885"/>
                    <a:pt x="3695700" y="20549"/>
                  </a:cubicBezTo>
                  <a:cubicBezTo>
                    <a:pt x="3599681" y="-11457"/>
                    <a:pt x="3639870" y="-1823"/>
                    <a:pt x="3438525" y="20549"/>
                  </a:cubicBezTo>
                  <a:cubicBezTo>
                    <a:pt x="3427147" y="21813"/>
                    <a:pt x="3420472" y="35090"/>
                    <a:pt x="3409950" y="39599"/>
                  </a:cubicBezTo>
                  <a:cubicBezTo>
                    <a:pt x="3381078" y="51973"/>
                    <a:pt x="3303334" y="56737"/>
                    <a:pt x="3286125" y="58649"/>
                  </a:cubicBezTo>
                  <a:cubicBezTo>
                    <a:pt x="3192705" y="89789"/>
                    <a:pt x="3248986" y="76031"/>
                    <a:pt x="3114675" y="87224"/>
                  </a:cubicBezTo>
                  <a:cubicBezTo>
                    <a:pt x="2943438" y="144303"/>
                    <a:pt x="3066551" y="106820"/>
                    <a:pt x="2628900" y="87224"/>
                  </a:cubicBezTo>
                  <a:cubicBezTo>
                    <a:pt x="2568302" y="84511"/>
                    <a:pt x="2508250" y="74524"/>
                    <a:pt x="2447925" y="68174"/>
                  </a:cubicBezTo>
                  <a:cubicBezTo>
                    <a:pt x="2435225" y="64999"/>
                    <a:pt x="2422867" y="59783"/>
                    <a:pt x="2409825" y="58649"/>
                  </a:cubicBezTo>
                  <a:lnTo>
                    <a:pt x="2200275" y="39599"/>
                  </a:lnTo>
                  <a:cubicBezTo>
                    <a:pt x="2060759" y="43087"/>
                    <a:pt x="1793492" y="46597"/>
                    <a:pt x="1628775" y="58649"/>
                  </a:cubicBezTo>
                  <a:cubicBezTo>
                    <a:pt x="1561977" y="63537"/>
                    <a:pt x="1495709" y="76177"/>
                    <a:pt x="1428750" y="77699"/>
                  </a:cubicBezTo>
                  <a:lnTo>
                    <a:pt x="1009650" y="87224"/>
                  </a:lnTo>
                  <a:cubicBezTo>
                    <a:pt x="984250" y="84049"/>
                    <a:pt x="958635" y="82278"/>
                    <a:pt x="933450" y="77699"/>
                  </a:cubicBezTo>
                  <a:cubicBezTo>
                    <a:pt x="923572" y="75903"/>
                    <a:pt x="914529" y="70932"/>
                    <a:pt x="904875" y="68174"/>
                  </a:cubicBezTo>
                  <a:cubicBezTo>
                    <a:pt x="892288" y="64578"/>
                    <a:pt x="879475" y="61824"/>
                    <a:pt x="866775" y="58649"/>
                  </a:cubicBezTo>
                  <a:cubicBezTo>
                    <a:pt x="793750" y="61824"/>
                    <a:pt x="719876" y="56626"/>
                    <a:pt x="647700" y="68174"/>
                  </a:cubicBezTo>
                  <a:cubicBezTo>
                    <a:pt x="626669" y="71539"/>
                    <a:pt x="629123" y="115326"/>
                    <a:pt x="619125" y="125324"/>
                  </a:cubicBezTo>
                  <a:cubicBezTo>
                    <a:pt x="609085" y="135364"/>
                    <a:pt x="594076" y="138781"/>
                    <a:pt x="581025" y="144374"/>
                  </a:cubicBezTo>
                  <a:cubicBezTo>
                    <a:pt x="521729" y="169787"/>
                    <a:pt x="451688" y="159826"/>
                    <a:pt x="390525" y="163424"/>
                  </a:cubicBezTo>
                  <a:cubicBezTo>
                    <a:pt x="355756" y="175014"/>
                    <a:pt x="357017" y="175906"/>
                    <a:pt x="314325" y="182474"/>
                  </a:cubicBezTo>
                  <a:cubicBezTo>
                    <a:pt x="289025" y="186366"/>
                    <a:pt x="263374" y="187791"/>
                    <a:pt x="238125" y="191999"/>
                  </a:cubicBezTo>
                  <a:cubicBezTo>
                    <a:pt x="225212" y="194151"/>
                    <a:pt x="212282" y="196927"/>
                    <a:pt x="200025" y="201524"/>
                  </a:cubicBezTo>
                  <a:cubicBezTo>
                    <a:pt x="186730" y="206510"/>
                    <a:pt x="176060" y="219228"/>
                    <a:pt x="161925" y="220574"/>
                  </a:cubicBezTo>
                  <a:cubicBezTo>
                    <a:pt x="108193" y="225691"/>
                    <a:pt x="53975" y="220574"/>
                    <a:pt x="0" y="220574"/>
                  </a:cubicBezTo>
                </a:path>
              </a:pathLst>
            </a:custGeom>
            <a:noFill/>
            <a:ln w="28575">
              <a:solidFill>
                <a:srgbClr val="FF0000">
                  <a:alpha val="60000"/>
                </a:srgbClr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7" name="Freihandform 16"/>
            <p:cNvSpPr/>
            <p:nvPr/>
          </p:nvSpPr>
          <p:spPr>
            <a:xfrm>
              <a:off x="2190750" y="2771775"/>
              <a:ext cx="1609725" cy="295275"/>
            </a:xfrm>
            <a:custGeom>
              <a:avLst/>
              <a:gdLst>
                <a:gd name="connsiteX0" fmla="*/ 1609725 w 1609725"/>
                <a:gd name="connsiteY0" fmla="*/ 285750 h 295275"/>
                <a:gd name="connsiteX1" fmla="*/ 1562100 w 1609725"/>
                <a:gd name="connsiteY1" fmla="*/ 295275 h 295275"/>
                <a:gd name="connsiteX2" fmla="*/ 1495425 w 1609725"/>
                <a:gd name="connsiteY2" fmla="*/ 276225 h 295275"/>
                <a:gd name="connsiteX3" fmla="*/ 1409700 w 1609725"/>
                <a:gd name="connsiteY3" fmla="*/ 266700 h 295275"/>
                <a:gd name="connsiteX4" fmla="*/ 1323975 w 1609725"/>
                <a:gd name="connsiteY4" fmla="*/ 247650 h 295275"/>
                <a:gd name="connsiteX5" fmla="*/ 1257300 w 1609725"/>
                <a:gd name="connsiteY5" fmla="*/ 238125 h 295275"/>
                <a:gd name="connsiteX6" fmla="*/ 1171575 w 1609725"/>
                <a:gd name="connsiteY6" fmla="*/ 190500 h 295275"/>
                <a:gd name="connsiteX7" fmla="*/ 1095375 w 1609725"/>
                <a:gd name="connsiteY7" fmla="*/ 161925 h 295275"/>
                <a:gd name="connsiteX8" fmla="*/ 1076325 w 1609725"/>
                <a:gd name="connsiteY8" fmla="*/ 133350 h 295275"/>
                <a:gd name="connsiteX9" fmla="*/ 952500 w 1609725"/>
                <a:gd name="connsiteY9" fmla="*/ 104775 h 295275"/>
                <a:gd name="connsiteX10" fmla="*/ 733425 w 1609725"/>
                <a:gd name="connsiteY10" fmla="*/ 95250 h 295275"/>
                <a:gd name="connsiteX11" fmla="*/ 704850 w 1609725"/>
                <a:gd name="connsiteY11" fmla="*/ 76200 h 295275"/>
                <a:gd name="connsiteX12" fmla="*/ 647700 w 1609725"/>
                <a:gd name="connsiteY12" fmla="*/ 66675 h 295275"/>
                <a:gd name="connsiteX13" fmla="*/ 552450 w 1609725"/>
                <a:gd name="connsiteY13" fmla="*/ 47625 h 295275"/>
                <a:gd name="connsiteX14" fmla="*/ 495300 w 1609725"/>
                <a:gd name="connsiteY14" fmla="*/ 38100 h 295275"/>
                <a:gd name="connsiteX15" fmla="*/ 438150 w 1609725"/>
                <a:gd name="connsiteY15" fmla="*/ 19050 h 295275"/>
                <a:gd name="connsiteX16" fmla="*/ 266700 w 1609725"/>
                <a:gd name="connsiteY16" fmla="*/ 0 h 295275"/>
                <a:gd name="connsiteX17" fmla="*/ 114300 w 1609725"/>
                <a:gd name="connsiteY17" fmla="*/ 9525 h 295275"/>
                <a:gd name="connsiteX18" fmla="*/ 104775 w 1609725"/>
                <a:gd name="connsiteY18" fmla="*/ 38100 h 295275"/>
                <a:gd name="connsiteX19" fmla="*/ 85725 w 1609725"/>
                <a:gd name="connsiteY19" fmla="*/ 66675 h 295275"/>
                <a:gd name="connsiteX20" fmla="*/ 57150 w 1609725"/>
                <a:gd name="connsiteY20" fmla="*/ 95250 h 295275"/>
                <a:gd name="connsiteX21" fmla="*/ 0 w 1609725"/>
                <a:gd name="connsiteY21" fmla="*/ 133350 h 2952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</a:cxnLst>
              <a:rect l="l" t="t" r="r" b="b"/>
              <a:pathLst>
                <a:path w="1609725" h="295275">
                  <a:moveTo>
                    <a:pt x="1609725" y="285750"/>
                  </a:moveTo>
                  <a:cubicBezTo>
                    <a:pt x="1593850" y="288925"/>
                    <a:pt x="1578289" y="295275"/>
                    <a:pt x="1562100" y="295275"/>
                  </a:cubicBezTo>
                  <a:cubicBezTo>
                    <a:pt x="1532570" y="295275"/>
                    <a:pt x="1522375" y="280717"/>
                    <a:pt x="1495425" y="276225"/>
                  </a:cubicBezTo>
                  <a:cubicBezTo>
                    <a:pt x="1467065" y="271498"/>
                    <a:pt x="1438275" y="269875"/>
                    <a:pt x="1409700" y="266700"/>
                  </a:cubicBezTo>
                  <a:cubicBezTo>
                    <a:pt x="1390672" y="209616"/>
                    <a:pt x="1413728" y="247650"/>
                    <a:pt x="1323975" y="247650"/>
                  </a:cubicBezTo>
                  <a:cubicBezTo>
                    <a:pt x="1301524" y="247650"/>
                    <a:pt x="1279525" y="241300"/>
                    <a:pt x="1257300" y="238125"/>
                  </a:cubicBezTo>
                  <a:cubicBezTo>
                    <a:pt x="1178279" y="211785"/>
                    <a:pt x="1302583" y="256004"/>
                    <a:pt x="1171575" y="190500"/>
                  </a:cubicBezTo>
                  <a:cubicBezTo>
                    <a:pt x="1121766" y="165596"/>
                    <a:pt x="1147250" y="174894"/>
                    <a:pt x="1095375" y="161925"/>
                  </a:cubicBezTo>
                  <a:cubicBezTo>
                    <a:pt x="1089025" y="152400"/>
                    <a:pt x="1086033" y="139417"/>
                    <a:pt x="1076325" y="133350"/>
                  </a:cubicBezTo>
                  <a:cubicBezTo>
                    <a:pt x="1049421" y="116535"/>
                    <a:pt x="981425" y="106703"/>
                    <a:pt x="952500" y="104775"/>
                  </a:cubicBezTo>
                  <a:cubicBezTo>
                    <a:pt x="879568" y="99913"/>
                    <a:pt x="806450" y="98425"/>
                    <a:pt x="733425" y="95250"/>
                  </a:cubicBezTo>
                  <a:cubicBezTo>
                    <a:pt x="723900" y="88900"/>
                    <a:pt x="715710" y="79820"/>
                    <a:pt x="704850" y="76200"/>
                  </a:cubicBezTo>
                  <a:cubicBezTo>
                    <a:pt x="686528" y="70093"/>
                    <a:pt x="666682" y="70234"/>
                    <a:pt x="647700" y="66675"/>
                  </a:cubicBezTo>
                  <a:cubicBezTo>
                    <a:pt x="615876" y="60708"/>
                    <a:pt x="584388" y="52948"/>
                    <a:pt x="552450" y="47625"/>
                  </a:cubicBezTo>
                  <a:cubicBezTo>
                    <a:pt x="533400" y="44450"/>
                    <a:pt x="514036" y="42784"/>
                    <a:pt x="495300" y="38100"/>
                  </a:cubicBezTo>
                  <a:cubicBezTo>
                    <a:pt x="475819" y="33230"/>
                    <a:pt x="458161" y="20718"/>
                    <a:pt x="438150" y="19050"/>
                  </a:cubicBezTo>
                  <a:cubicBezTo>
                    <a:pt x="304604" y="7921"/>
                    <a:pt x="361562" y="15810"/>
                    <a:pt x="266700" y="0"/>
                  </a:cubicBezTo>
                  <a:cubicBezTo>
                    <a:pt x="215900" y="3175"/>
                    <a:pt x="163846" y="-2133"/>
                    <a:pt x="114300" y="9525"/>
                  </a:cubicBezTo>
                  <a:cubicBezTo>
                    <a:pt x="104527" y="11825"/>
                    <a:pt x="109265" y="29120"/>
                    <a:pt x="104775" y="38100"/>
                  </a:cubicBezTo>
                  <a:cubicBezTo>
                    <a:pt x="99655" y="48339"/>
                    <a:pt x="93054" y="57881"/>
                    <a:pt x="85725" y="66675"/>
                  </a:cubicBezTo>
                  <a:cubicBezTo>
                    <a:pt x="77101" y="77023"/>
                    <a:pt x="67783" y="86980"/>
                    <a:pt x="57150" y="95250"/>
                  </a:cubicBezTo>
                  <a:cubicBezTo>
                    <a:pt x="39078" y="109306"/>
                    <a:pt x="0" y="133350"/>
                    <a:pt x="0" y="133350"/>
                  </a:cubicBezTo>
                </a:path>
              </a:pathLst>
            </a:custGeom>
            <a:noFill/>
            <a:ln w="28575">
              <a:solidFill>
                <a:srgbClr val="FF0000">
                  <a:alpha val="60000"/>
                </a:srgbClr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9" name="Freihandform 18"/>
            <p:cNvSpPr/>
            <p:nvPr/>
          </p:nvSpPr>
          <p:spPr>
            <a:xfrm>
              <a:off x="1857375" y="2647950"/>
              <a:ext cx="485775" cy="142875"/>
            </a:xfrm>
            <a:custGeom>
              <a:avLst/>
              <a:gdLst>
                <a:gd name="connsiteX0" fmla="*/ 485775 w 485775"/>
                <a:gd name="connsiteY0" fmla="*/ 142875 h 142875"/>
                <a:gd name="connsiteX1" fmla="*/ 438150 w 485775"/>
                <a:gd name="connsiteY1" fmla="*/ 114300 h 142875"/>
                <a:gd name="connsiteX2" fmla="*/ 409575 w 485775"/>
                <a:gd name="connsiteY2" fmla="*/ 104775 h 142875"/>
                <a:gd name="connsiteX3" fmla="*/ 352425 w 485775"/>
                <a:gd name="connsiteY3" fmla="*/ 66675 h 142875"/>
                <a:gd name="connsiteX4" fmla="*/ 323850 w 485775"/>
                <a:gd name="connsiteY4" fmla="*/ 47625 h 142875"/>
                <a:gd name="connsiteX5" fmla="*/ 228600 w 485775"/>
                <a:gd name="connsiteY5" fmla="*/ 28575 h 142875"/>
                <a:gd name="connsiteX6" fmla="*/ 200025 w 485775"/>
                <a:gd name="connsiteY6" fmla="*/ 19050 h 142875"/>
                <a:gd name="connsiteX7" fmla="*/ 114300 w 485775"/>
                <a:gd name="connsiteY7" fmla="*/ 0 h 142875"/>
                <a:gd name="connsiteX8" fmla="*/ 76200 w 485775"/>
                <a:gd name="connsiteY8" fmla="*/ 9525 h 142875"/>
                <a:gd name="connsiteX9" fmla="*/ 47625 w 485775"/>
                <a:gd name="connsiteY9" fmla="*/ 28575 h 142875"/>
                <a:gd name="connsiteX10" fmla="*/ 0 w 485775"/>
                <a:gd name="connsiteY10" fmla="*/ 28575 h 1428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485775" h="142875">
                  <a:moveTo>
                    <a:pt x="485775" y="142875"/>
                  </a:moveTo>
                  <a:cubicBezTo>
                    <a:pt x="469900" y="133350"/>
                    <a:pt x="454709" y="122579"/>
                    <a:pt x="438150" y="114300"/>
                  </a:cubicBezTo>
                  <a:cubicBezTo>
                    <a:pt x="429170" y="109810"/>
                    <a:pt x="418352" y="109651"/>
                    <a:pt x="409575" y="104775"/>
                  </a:cubicBezTo>
                  <a:cubicBezTo>
                    <a:pt x="389561" y="93656"/>
                    <a:pt x="371475" y="79375"/>
                    <a:pt x="352425" y="66675"/>
                  </a:cubicBezTo>
                  <a:cubicBezTo>
                    <a:pt x="342900" y="60325"/>
                    <a:pt x="335142" y="49507"/>
                    <a:pt x="323850" y="47625"/>
                  </a:cubicBezTo>
                  <a:cubicBezTo>
                    <a:pt x="278942" y="40140"/>
                    <a:pt x="268385" y="39942"/>
                    <a:pt x="228600" y="28575"/>
                  </a:cubicBezTo>
                  <a:cubicBezTo>
                    <a:pt x="218946" y="25817"/>
                    <a:pt x="209826" y="21228"/>
                    <a:pt x="200025" y="19050"/>
                  </a:cubicBezTo>
                  <a:cubicBezTo>
                    <a:pt x="99445" y="-3301"/>
                    <a:pt x="178626" y="21442"/>
                    <a:pt x="114300" y="0"/>
                  </a:cubicBezTo>
                  <a:cubicBezTo>
                    <a:pt x="101600" y="3175"/>
                    <a:pt x="88232" y="4368"/>
                    <a:pt x="76200" y="9525"/>
                  </a:cubicBezTo>
                  <a:cubicBezTo>
                    <a:pt x="65678" y="14034"/>
                    <a:pt x="58731" y="25799"/>
                    <a:pt x="47625" y="28575"/>
                  </a:cubicBezTo>
                  <a:cubicBezTo>
                    <a:pt x="32224" y="32425"/>
                    <a:pt x="15875" y="28575"/>
                    <a:pt x="0" y="28575"/>
                  </a:cubicBezTo>
                </a:path>
              </a:pathLst>
            </a:cu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0" name="Freihandform 19"/>
            <p:cNvSpPr/>
            <p:nvPr/>
          </p:nvSpPr>
          <p:spPr>
            <a:xfrm>
              <a:off x="3827945" y="3067050"/>
              <a:ext cx="6020905" cy="1419225"/>
            </a:xfrm>
            <a:custGeom>
              <a:avLst/>
              <a:gdLst>
                <a:gd name="connsiteX0" fmla="*/ 6020905 w 6020905"/>
                <a:gd name="connsiteY0" fmla="*/ 361950 h 1419225"/>
                <a:gd name="connsiteX1" fmla="*/ 6001855 w 6020905"/>
                <a:gd name="connsiteY1" fmla="*/ 542925 h 1419225"/>
                <a:gd name="connsiteX2" fmla="*/ 5982805 w 6020905"/>
                <a:gd name="connsiteY2" fmla="*/ 571500 h 1419225"/>
                <a:gd name="connsiteX3" fmla="*/ 5954230 w 6020905"/>
                <a:gd name="connsiteY3" fmla="*/ 657225 h 1419225"/>
                <a:gd name="connsiteX4" fmla="*/ 5897080 w 6020905"/>
                <a:gd name="connsiteY4" fmla="*/ 676275 h 1419225"/>
                <a:gd name="connsiteX5" fmla="*/ 5792305 w 6020905"/>
                <a:gd name="connsiteY5" fmla="*/ 695325 h 1419225"/>
                <a:gd name="connsiteX6" fmla="*/ 5735155 w 6020905"/>
                <a:gd name="connsiteY6" fmla="*/ 723900 h 1419225"/>
                <a:gd name="connsiteX7" fmla="*/ 5706580 w 6020905"/>
                <a:gd name="connsiteY7" fmla="*/ 733425 h 1419225"/>
                <a:gd name="connsiteX8" fmla="*/ 5658955 w 6020905"/>
                <a:gd name="connsiteY8" fmla="*/ 752475 h 1419225"/>
                <a:gd name="connsiteX9" fmla="*/ 5620855 w 6020905"/>
                <a:gd name="connsiteY9" fmla="*/ 762000 h 1419225"/>
                <a:gd name="connsiteX10" fmla="*/ 5592280 w 6020905"/>
                <a:gd name="connsiteY10" fmla="*/ 771525 h 1419225"/>
                <a:gd name="connsiteX11" fmla="*/ 5439880 w 6020905"/>
                <a:gd name="connsiteY11" fmla="*/ 762000 h 1419225"/>
                <a:gd name="connsiteX12" fmla="*/ 5411305 w 6020905"/>
                <a:gd name="connsiteY12" fmla="*/ 752475 h 1419225"/>
                <a:gd name="connsiteX13" fmla="*/ 5335105 w 6020905"/>
                <a:gd name="connsiteY13" fmla="*/ 762000 h 1419225"/>
                <a:gd name="connsiteX14" fmla="*/ 5316055 w 6020905"/>
                <a:gd name="connsiteY14" fmla="*/ 790575 h 1419225"/>
                <a:gd name="connsiteX15" fmla="*/ 5287480 w 6020905"/>
                <a:gd name="connsiteY15" fmla="*/ 828675 h 1419225"/>
                <a:gd name="connsiteX16" fmla="*/ 5249380 w 6020905"/>
                <a:gd name="connsiteY16" fmla="*/ 876300 h 1419225"/>
                <a:gd name="connsiteX17" fmla="*/ 5192230 w 6020905"/>
                <a:gd name="connsiteY17" fmla="*/ 981075 h 1419225"/>
                <a:gd name="connsiteX18" fmla="*/ 5106505 w 6020905"/>
                <a:gd name="connsiteY18" fmla="*/ 1047750 h 1419225"/>
                <a:gd name="connsiteX19" fmla="*/ 5049355 w 6020905"/>
                <a:gd name="connsiteY19" fmla="*/ 1066800 h 1419225"/>
                <a:gd name="connsiteX20" fmla="*/ 5020780 w 6020905"/>
                <a:gd name="connsiteY20" fmla="*/ 1085850 h 1419225"/>
                <a:gd name="connsiteX21" fmla="*/ 4963630 w 6020905"/>
                <a:gd name="connsiteY21" fmla="*/ 1095375 h 1419225"/>
                <a:gd name="connsiteX22" fmla="*/ 4935055 w 6020905"/>
                <a:gd name="connsiteY22" fmla="*/ 1104900 h 1419225"/>
                <a:gd name="connsiteX23" fmla="*/ 4820755 w 6020905"/>
                <a:gd name="connsiteY23" fmla="*/ 1095375 h 1419225"/>
                <a:gd name="connsiteX24" fmla="*/ 4725505 w 6020905"/>
                <a:gd name="connsiteY24" fmla="*/ 1076325 h 1419225"/>
                <a:gd name="connsiteX25" fmla="*/ 4630255 w 6020905"/>
                <a:gd name="connsiteY25" fmla="*/ 1066800 h 1419225"/>
                <a:gd name="connsiteX26" fmla="*/ 4468330 w 6020905"/>
                <a:gd name="connsiteY26" fmla="*/ 1076325 h 1419225"/>
                <a:gd name="connsiteX27" fmla="*/ 4449280 w 6020905"/>
                <a:gd name="connsiteY27" fmla="*/ 1104900 h 1419225"/>
                <a:gd name="connsiteX28" fmla="*/ 4363555 w 6020905"/>
                <a:gd name="connsiteY28" fmla="*/ 1152525 h 1419225"/>
                <a:gd name="connsiteX29" fmla="*/ 4315930 w 6020905"/>
                <a:gd name="connsiteY29" fmla="*/ 1162050 h 1419225"/>
                <a:gd name="connsiteX30" fmla="*/ 4287355 w 6020905"/>
                <a:gd name="connsiteY30" fmla="*/ 1171575 h 1419225"/>
                <a:gd name="connsiteX31" fmla="*/ 4106380 w 6020905"/>
                <a:gd name="connsiteY31" fmla="*/ 1181100 h 1419225"/>
                <a:gd name="connsiteX32" fmla="*/ 4087330 w 6020905"/>
                <a:gd name="connsiteY32" fmla="*/ 1209675 h 1419225"/>
                <a:gd name="connsiteX33" fmla="*/ 4058755 w 6020905"/>
                <a:gd name="connsiteY33" fmla="*/ 1238250 h 1419225"/>
                <a:gd name="connsiteX34" fmla="*/ 4049230 w 6020905"/>
                <a:gd name="connsiteY34" fmla="*/ 1266825 h 1419225"/>
                <a:gd name="connsiteX35" fmla="*/ 4011130 w 6020905"/>
                <a:gd name="connsiteY35" fmla="*/ 1371600 h 1419225"/>
                <a:gd name="connsiteX36" fmla="*/ 3944455 w 6020905"/>
                <a:gd name="connsiteY36" fmla="*/ 1400175 h 1419225"/>
                <a:gd name="connsiteX37" fmla="*/ 3887305 w 6020905"/>
                <a:gd name="connsiteY37" fmla="*/ 1419225 h 1419225"/>
                <a:gd name="connsiteX38" fmla="*/ 3811105 w 6020905"/>
                <a:gd name="connsiteY38" fmla="*/ 1409700 h 1419225"/>
                <a:gd name="connsiteX39" fmla="*/ 3753955 w 6020905"/>
                <a:gd name="connsiteY39" fmla="*/ 1381125 h 1419225"/>
                <a:gd name="connsiteX40" fmla="*/ 3668230 w 6020905"/>
                <a:gd name="connsiteY40" fmla="*/ 1371600 h 1419225"/>
                <a:gd name="connsiteX41" fmla="*/ 3639655 w 6020905"/>
                <a:gd name="connsiteY41" fmla="*/ 1352550 h 1419225"/>
                <a:gd name="connsiteX42" fmla="*/ 3611080 w 6020905"/>
                <a:gd name="connsiteY42" fmla="*/ 1343025 h 1419225"/>
                <a:gd name="connsiteX43" fmla="*/ 3496780 w 6020905"/>
                <a:gd name="connsiteY43" fmla="*/ 1266825 h 1419225"/>
                <a:gd name="connsiteX44" fmla="*/ 3439630 w 6020905"/>
                <a:gd name="connsiteY44" fmla="*/ 1247775 h 1419225"/>
                <a:gd name="connsiteX45" fmla="*/ 3411055 w 6020905"/>
                <a:gd name="connsiteY45" fmla="*/ 1238250 h 1419225"/>
                <a:gd name="connsiteX46" fmla="*/ 3382480 w 6020905"/>
                <a:gd name="connsiteY46" fmla="*/ 1228725 h 1419225"/>
                <a:gd name="connsiteX47" fmla="*/ 3325330 w 6020905"/>
                <a:gd name="connsiteY47" fmla="*/ 1190625 h 1419225"/>
                <a:gd name="connsiteX48" fmla="*/ 3296755 w 6020905"/>
                <a:gd name="connsiteY48" fmla="*/ 1171575 h 1419225"/>
                <a:gd name="connsiteX49" fmla="*/ 3258655 w 6020905"/>
                <a:gd name="connsiteY49" fmla="*/ 1162050 h 1419225"/>
                <a:gd name="connsiteX50" fmla="*/ 3220555 w 6020905"/>
                <a:gd name="connsiteY50" fmla="*/ 1143000 h 1419225"/>
                <a:gd name="connsiteX51" fmla="*/ 3163405 w 6020905"/>
                <a:gd name="connsiteY51" fmla="*/ 1123950 h 1419225"/>
                <a:gd name="connsiteX52" fmla="*/ 3106255 w 6020905"/>
                <a:gd name="connsiteY52" fmla="*/ 1085850 h 1419225"/>
                <a:gd name="connsiteX53" fmla="*/ 3049105 w 6020905"/>
                <a:gd name="connsiteY53" fmla="*/ 1047750 h 1419225"/>
                <a:gd name="connsiteX54" fmla="*/ 2963380 w 6020905"/>
                <a:gd name="connsiteY54" fmla="*/ 1057275 h 1419225"/>
                <a:gd name="connsiteX55" fmla="*/ 2934805 w 6020905"/>
                <a:gd name="connsiteY55" fmla="*/ 1066800 h 1419225"/>
                <a:gd name="connsiteX56" fmla="*/ 2877655 w 6020905"/>
                <a:gd name="connsiteY56" fmla="*/ 1123950 h 1419225"/>
                <a:gd name="connsiteX57" fmla="*/ 2830030 w 6020905"/>
                <a:gd name="connsiteY57" fmla="*/ 1133475 h 1419225"/>
                <a:gd name="connsiteX58" fmla="*/ 2772880 w 6020905"/>
                <a:gd name="connsiteY58" fmla="*/ 1152525 h 1419225"/>
                <a:gd name="connsiteX59" fmla="*/ 2734780 w 6020905"/>
                <a:gd name="connsiteY59" fmla="*/ 1162050 h 1419225"/>
                <a:gd name="connsiteX60" fmla="*/ 2582380 w 6020905"/>
                <a:gd name="connsiteY60" fmla="*/ 1219200 h 1419225"/>
                <a:gd name="connsiteX61" fmla="*/ 2582380 w 6020905"/>
                <a:gd name="connsiteY61" fmla="*/ 1219200 h 1419225"/>
                <a:gd name="connsiteX62" fmla="*/ 2525230 w 6020905"/>
                <a:gd name="connsiteY62" fmla="*/ 1238250 h 1419225"/>
                <a:gd name="connsiteX63" fmla="*/ 2401405 w 6020905"/>
                <a:gd name="connsiteY63" fmla="*/ 1200150 h 1419225"/>
                <a:gd name="connsiteX64" fmla="*/ 2372830 w 6020905"/>
                <a:gd name="connsiteY64" fmla="*/ 1190625 h 1419225"/>
                <a:gd name="connsiteX65" fmla="*/ 2239480 w 6020905"/>
                <a:gd name="connsiteY65" fmla="*/ 1200150 h 1419225"/>
                <a:gd name="connsiteX66" fmla="*/ 2182330 w 6020905"/>
                <a:gd name="connsiteY66" fmla="*/ 1228725 h 1419225"/>
                <a:gd name="connsiteX67" fmla="*/ 2153755 w 6020905"/>
                <a:gd name="connsiteY67" fmla="*/ 1238250 h 1419225"/>
                <a:gd name="connsiteX68" fmla="*/ 2068030 w 6020905"/>
                <a:gd name="connsiteY68" fmla="*/ 1228725 h 1419225"/>
                <a:gd name="connsiteX69" fmla="*/ 2029930 w 6020905"/>
                <a:gd name="connsiteY69" fmla="*/ 1219200 h 1419225"/>
                <a:gd name="connsiteX70" fmla="*/ 1820380 w 6020905"/>
                <a:gd name="connsiteY70" fmla="*/ 1228725 h 1419225"/>
                <a:gd name="connsiteX71" fmla="*/ 1763230 w 6020905"/>
                <a:gd name="connsiteY71" fmla="*/ 1247775 h 1419225"/>
                <a:gd name="connsiteX72" fmla="*/ 1677505 w 6020905"/>
                <a:gd name="connsiteY72" fmla="*/ 1266825 h 1419225"/>
                <a:gd name="connsiteX73" fmla="*/ 1591780 w 6020905"/>
                <a:gd name="connsiteY73" fmla="*/ 1314450 h 1419225"/>
                <a:gd name="connsiteX74" fmla="*/ 1553680 w 6020905"/>
                <a:gd name="connsiteY74" fmla="*/ 1333500 h 1419225"/>
                <a:gd name="connsiteX75" fmla="*/ 1372705 w 6020905"/>
                <a:gd name="connsiteY75" fmla="*/ 1343025 h 1419225"/>
                <a:gd name="connsiteX76" fmla="*/ 1286980 w 6020905"/>
                <a:gd name="connsiteY76" fmla="*/ 1333500 h 1419225"/>
                <a:gd name="connsiteX77" fmla="*/ 1277455 w 6020905"/>
                <a:gd name="connsiteY77" fmla="*/ 1304925 h 1419225"/>
                <a:gd name="connsiteX78" fmla="*/ 1210780 w 6020905"/>
                <a:gd name="connsiteY78" fmla="*/ 1276350 h 1419225"/>
                <a:gd name="connsiteX79" fmla="*/ 1153630 w 6020905"/>
                <a:gd name="connsiteY79" fmla="*/ 1238250 h 1419225"/>
                <a:gd name="connsiteX80" fmla="*/ 1096480 w 6020905"/>
                <a:gd name="connsiteY80" fmla="*/ 1209675 h 1419225"/>
                <a:gd name="connsiteX81" fmla="*/ 1020280 w 6020905"/>
                <a:gd name="connsiteY81" fmla="*/ 1123950 h 1419225"/>
                <a:gd name="connsiteX82" fmla="*/ 991705 w 6020905"/>
                <a:gd name="connsiteY82" fmla="*/ 1104900 h 1419225"/>
                <a:gd name="connsiteX83" fmla="*/ 944080 w 6020905"/>
                <a:gd name="connsiteY83" fmla="*/ 1095375 h 1419225"/>
                <a:gd name="connsiteX84" fmla="*/ 839305 w 6020905"/>
                <a:gd name="connsiteY84" fmla="*/ 1057275 h 1419225"/>
                <a:gd name="connsiteX85" fmla="*/ 810730 w 6020905"/>
                <a:gd name="connsiteY85" fmla="*/ 1047750 h 1419225"/>
                <a:gd name="connsiteX86" fmla="*/ 744055 w 6020905"/>
                <a:gd name="connsiteY86" fmla="*/ 1009650 h 1419225"/>
                <a:gd name="connsiteX87" fmla="*/ 686905 w 6020905"/>
                <a:gd name="connsiteY87" fmla="*/ 990600 h 1419225"/>
                <a:gd name="connsiteX88" fmla="*/ 658330 w 6020905"/>
                <a:gd name="connsiteY88" fmla="*/ 971550 h 1419225"/>
                <a:gd name="connsiteX89" fmla="*/ 620230 w 6020905"/>
                <a:gd name="connsiteY89" fmla="*/ 962025 h 1419225"/>
                <a:gd name="connsiteX90" fmla="*/ 591655 w 6020905"/>
                <a:gd name="connsiteY90" fmla="*/ 952500 h 1419225"/>
                <a:gd name="connsiteX91" fmla="*/ 496405 w 6020905"/>
                <a:gd name="connsiteY91" fmla="*/ 885825 h 1419225"/>
                <a:gd name="connsiteX92" fmla="*/ 467830 w 6020905"/>
                <a:gd name="connsiteY92" fmla="*/ 866775 h 1419225"/>
                <a:gd name="connsiteX93" fmla="*/ 439255 w 6020905"/>
                <a:gd name="connsiteY93" fmla="*/ 838200 h 1419225"/>
                <a:gd name="connsiteX94" fmla="*/ 382105 w 6020905"/>
                <a:gd name="connsiteY94" fmla="*/ 800100 h 1419225"/>
                <a:gd name="connsiteX95" fmla="*/ 353530 w 6020905"/>
                <a:gd name="connsiteY95" fmla="*/ 771525 h 1419225"/>
                <a:gd name="connsiteX96" fmla="*/ 296380 w 6020905"/>
                <a:gd name="connsiteY96" fmla="*/ 733425 h 1419225"/>
                <a:gd name="connsiteX97" fmla="*/ 267805 w 6020905"/>
                <a:gd name="connsiteY97" fmla="*/ 704850 h 1419225"/>
                <a:gd name="connsiteX98" fmla="*/ 201130 w 6020905"/>
                <a:gd name="connsiteY98" fmla="*/ 666750 h 1419225"/>
                <a:gd name="connsiteX99" fmla="*/ 182080 w 6020905"/>
                <a:gd name="connsiteY99" fmla="*/ 638175 h 1419225"/>
                <a:gd name="connsiteX100" fmla="*/ 172555 w 6020905"/>
                <a:gd name="connsiteY100" fmla="*/ 609600 h 1419225"/>
                <a:gd name="connsiteX101" fmla="*/ 143980 w 6020905"/>
                <a:gd name="connsiteY101" fmla="*/ 581025 h 1419225"/>
                <a:gd name="connsiteX102" fmla="*/ 86830 w 6020905"/>
                <a:gd name="connsiteY102" fmla="*/ 514350 h 1419225"/>
                <a:gd name="connsiteX103" fmla="*/ 77305 w 6020905"/>
                <a:gd name="connsiteY103" fmla="*/ 485775 h 1419225"/>
                <a:gd name="connsiteX104" fmla="*/ 96355 w 6020905"/>
                <a:gd name="connsiteY104" fmla="*/ 400050 h 1419225"/>
                <a:gd name="connsiteX105" fmla="*/ 58255 w 6020905"/>
                <a:gd name="connsiteY105" fmla="*/ 228600 h 1419225"/>
                <a:gd name="connsiteX106" fmla="*/ 29680 w 6020905"/>
                <a:gd name="connsiteY106" fmla="*/ 200025 h 1419225"/>
                <a:gd name="connsiteX107" fmla="*/ 10630 w 6020905"/>
                <a:gd name="connsiteY107" fmla="*/ 133350 h 1419225"/>
                <a:gd name="connsiteX108" fmla="*/ 1105 w 6020905"/>
                <a:gd name="connsiteY108" fmla="*/ 104775 h 1419225"/>
                <a:gd name="connsiteX109" fmla="*/ 1105 w 6020905"/>
                <a:gd name="connsiteY109" fmla="*/ 0 h 14192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</a:cxnLst>
              <a:rect l="l" t="t" r="r" b="b"/>
              <a:pathLst>
                <a:path w="6020905" h="1419225">
                  <a:moveTo>
                    <a:pt x="6020905" y="361950"/>
                  </a:moveTo>
                  <a:cubicBezTo>
                    <a:pt x="6014555" y="422275"/>
                    <a:pt x="6012706" y="483245"/>
                    <a:pt x="6001855" y="542925"/>
                  </a:cubicBezTo>
                  <a:cubicBezTo>
                    <a:pt x="5999807" y="554188"/>
                    <a:pt x="5986425" y="560640"/>
                    <a:pt x="5982805" y="571500"/>
                  </a:cubicBezTo>
                  <a:cubicBezTo>
                    <a:pt x="5975488" y="593450"/>
                    <a:pt x="5981568" y="640139"/>
                    <a:pt x="5954230" y="657225"/>
                  </a:cubicBezTo>
                  <a:cubicBezTo>
                    <a:pt x="5937202" y="667868"/>
                    <a:pt x="5916887" y="672974"/>
                    <a:pt x="5897080" y="676275"/>
                  </a:cubicBezTo>
                  <a:cubicBezTo>
                    <a:pt x="5871604" y="680521"/>
                    <a:pt x="5818930" y="688669"/>
                    <a:pt x="5792305" y="695325"/>
                  </a:cubicBezTo>
                  <a:cubicBezTo>
                    <a:pt x="5744422" y="707296"/>
                    <a:pt x="5781716" y="700620"/>
                    <a:pt x="5735155" y="723900"/>
                  </a:cubicBezTo>
                  <a:cubicBezTo>
                    <a:pt x="5726175" y="728390"/>
                    <a:pt x="5715981" y="729900"/>
                    <a:pt x="5706580" y="733425"/>
                  </a:cubicBezTo>
                  <a:cubicBezTo>
                    <a:pt x="5690571" y="739428"/>
                    <a:pt x="5675175" y="747068"/>
                    <a:pt x="5658955" y="752475"/>
                  </a:cubicBezTo>
                  <a:cubicBezTo>
                    <a:pt x="5646536" y="756615"/>
                    <a:pt x="5633442" y="758404"/>
                    <a:pt x="5620855" y="762000"/>
                  </a:cubicBezTo>
                  <a:cubicBezTo>
                    <a:pt x="5611201" y="764758"/>
                    <a:pt x="5601805" y="768350"/>
                    <a:pt x="5592280" y="771525"/>
                  </a:cubicBezTo>
                  <a:cubicBezTo>
                    <a:pt x="5541480" y="768350"/>
                    <a:pt x="5490499" y="767328"/>
                    <a:pt x="5439880" y="762000"/>
                  </a:cubicBezTo>
                  <a:cubicBezTo>
                    <a:pt x="5429895" y="760949"/>
                    <a:pt x="5421345" y="752475"/>
                    <a:pt x="5411305" y="752475"/>
                  </a:cubicBezTo>
                  <a:cubicBezTo>
                    <a:pt x="5385707" y="752475"/>
                    <a:pt x="5360505" y="758825"/>
                    <a:pt x="5335105" y="762000"/>
                  </a:cubicBezTo>
                  <a:cubicBezTo>
                    <a:pt x="5328755" y="771525"/>
                    <a:pt x="5322709" y="781260"/>
                    <a:pt x="5316055" y="790575"/>
                  </a:cubicBezTo>
                  <a:cubicBezTo>
                    <a:pt x="5306828" y="803493"/>
                    <a:pt x="5295356" y="814892"/>
                    <a:pt x="5287480" y="828675"/>
                  </a:cubicBezTo>
                  <a:cubicBezTo>
                    <a:pt x="5259168" y="878222"/>
                    <a:pt x="5303602" y="840152"/>
                    <a:pt x="5249380" y="876300"/>
                  </a:cubicBezTo>
                  <a:cubicBezTo>
                    <a:pt x="5238536" y="897988"/>
                    <a:pt x="5213982" y="954973"/>
                    <a:pt x="5192230" y="981075"/>
                  </a:cubicBezTo>
                  <a:cubicBezTo>
                    <a:pt x="5173264" y="1003834"/>
                    <a:pt x="5131013" y="1039581"/>
                    <a:pt x="5106505" y="1047750"/>
                  </a:cubicBezTo>
                  <a:cubicBezTo>
                    <a:pt x="5087455" y="1054100"/>
                    <a:pt x="5066063" y="1055661"/>
                    <a:pt x="5049355" y="1066800"/>
                  </a:cubicBezTo>
                  <a:cubicBezTo>
                    <a:pt x="5039830" y="1073150"/>
                    <a:pt x="5031640" y="1082230"/>
                    <a:pt x="5020780" y="1085850"/>
                  </a:cubicBezTo>
                  <a:cubicBezTo>
                    <a:pt x="5002458" y="1091957"/>
                    <a:pt x="4982483" y="1091185"/>
                    <a:pt x="4963630" y="1095375"/>
                  </a:cubicBezTo>
                  <a:cubicBezTo>
                    <a:pt x="4953829" y="1097553"/>
                    <a:pt x="4944580" y="1101725"/>
                    <a:pt x="4935055" y="1104900"/>
                  </a:cubicBezTo>
                  <a:cubicBezTo>
                    <a:pt x="4896955" y="1101725"/>
                    <a:pt x="4858636" y="1100541"/>
                    <a:pt x="4820755" y="1095375"/>
                  </a:cubicBezTo>
                  <a:cubicBezTo>
                    <a:pt x="4788673" y="1091000"/>
                    <a:pt x="4757526" y="1081128"/>
                    <a:pt x="4725505" y="1076325"/>
                  </a:cubicBezTo>
                  <a:cubicBezTo>
                    <a:pt x="4693950" y="1071592"/>
                    <a:pt x="4662005" y="1069975"/>
                    <a:pt x="4630255" y="1066800"/>
                  </a:cubicBezTo>
                  <a:cubicBezTo>
                    <a:pt x="4576280" y="1069975"/>
                    <a:pt x="4521239" y="1065186"/>
                    <a:pt x="4468330" y="1076325"/>
                  </a:cubicBezTo>
                  <a:cubicBezTo>
                    <a:pt x="4457128" y="1078683"/>
                    <a:pt x="4457895" y="1097362"/>
                    <a:pt x="4449280" y="1104900"/>
                  </a:cubicBezTo>
                  <a:cubicBezTo>
                    <a:pt x="4420903" y="1129730"/>
                    <a:pt x="4397569" y="1144021"/>
                    <a:pt x="4363555" y="1152525"/>
                  </a:cubicBezTo>
                  <a:cubicBezTo>
                    <a:pt x="4347849" y="1156452"/>
                    <a:pt x="4331636" y="1158123"/>
                    <a:pt x="4315930" y="1162050"/>
                  </a:cubicBezTo>
                  <a:cubicBezTo>
                    <a:pt x="4306190" y="1164485"/>
                    <a:pt x="4297354" y="1170666"/>
                    <a:pt x="4287355" y="1171575"/>
                  </a:cubicBezTo>
                  <a:cubicBezTo>
                    <a:pt x="4227195" y="1177044"/>
                    <a:pt x="4166705" y="1177925"/>
                    <a:pt x="4106380" y="1181100"/>
                  </a:cubicBezTo>
                  <a:cubicBezTo>
                    <a:pt x="4100030" y="1190625"/>
                    <a:pt x="4094659" y="1200881"/>
                    <a:pt x="4087330" y="1209675"/>
                  </a:cubicBezTo>
                  <a:cubicBezTo>
                    <a:pt x="4078706" y="1220023"/>
                    <a:pt x="4066227" y="1227042"/>
                    <a:pt x="4058755" y="1238250"/>
                  </a:cubicBezTo>
                  <a:cubicBezTo>
                    <a:pt x="4053186" y="1246604"/>
                    <a:pt x="4051872" y="1257139"/>
                    <a:pt x="4049230" y="1266825"/>
                  </a:cubicBezTo>
                  <a:cubicBezTo>
                    <a:pt x="4039072" y="1304070"/>
                    <a:pt x="4039601" y="1343129"/>
                    <a:pt x="4011130" y="1371600"/>
                  </a:cubicBezTo>
                  <a:cubicBezTo>
                    <a:pt x="3987383" y="1395347"/>
                    <a:pt x="3975684" y="1390806"/>
                    <a:pt x="3944455" y="1400175"/>
                  </a:cubicBezTo>
                  <a:cubicBezTo>
                    <a:pt x="3925221" y="1405945"/>
                    <a:pt x="3887305" y="1419225"/>
                    <a:pt x="3887305" y="1419225"/>
                  </a:cubicBezTo>
                  <a:cubicBezTo>
                    <a:pt x="3861905" y="1416050"/>
                    <a:pt x="3835801" y="1416435"/>
                    <a:pt x="3811105" y="1409700"/>
                  </a:cubicBezTo>
                  <a:cubicBezTo>
                    <a:pt x="3707667" y="1381490"/>
                    <a:pt x="3851722" y="1397420"/>
                    <a:pt x="3753955" y="1381125"/>
                  </a:cubicBezTo>
                  <a:cubicBezTo>
                    <a:pt x="3725595" y="1376398"/>
                    <a:pt x="3696805" y="1374775"/>
                    <a:pt x="3668230" y="1371600"/>
                  </a:cubicBezTo>
                  <a:cubicBezTo>
                    <a:pt x="3658705" y="1365250"/>
                    <a:pt x="3649894" y="1357670"/>
                    <a:pt x="3639655" y="1352550"/>
                  </a:cubicBezTo>
                  <a:cubicBezTo>
                    <a:pt x="3630675" y="1348060"/>
                    <a:pt x="3619551" y="1348415"/>
                    <a:pt x="3611080" y="1343025"/>
                  </a:cubicBezTo>
                  <a:cubicBezTo>
                    <a:pt x="3544334" y="1300550"/>
                    <a:pt x="3553970" y="1289701"/>
                    <a:pt x="3496780" y="1266825"/>
                  </a:cubicBezTo>
                  <a:cubicBezTo>
                    <a:pt x="3478136" y="1259367"/>
                    <a:pt x="3458680" y="1254125"/>
                    <a:pt x="3439630" y="1247775"/>
                  </a:cubicBezTo>
                  <a:lnTo>
                    <a:pt x="3411055" y="1238250"/>
                  </a:lnTo>
                  <a:lnTo>
                    <a:pt x="3382480" y="1228725"/>
                  </a:lnTo>
                  <a:cubicBezTo>
                    <a:pt x="3328311" y="1174556"/>
                    <a:pt x="3380469" y="1218194"/>
                    <a:pt x="3325330" y="1190625"/>
                  </a:cubicBezTo>
                  <a:cubicBezTo>
                    <a:pt x="3315091" y="1185505"/>
                    <a:pt x="3307277" y="1176084"/>
                    <a:pt x="3296755" y="1171575"/>
                  </a:cubicBezTo>
                  <a:cubicBezTo>
                    <a:pt x="3284723" y="1166418"/>
                    <a:pt x="3270912" y="1166647"/>
                    <a:pt x="3258655" y="1162050"/>
                  </a:cubicBezTo>
                  <a:cubicBezTo>
                    <a:pt x="3245360" y="1157064"/>
                    <a:pt x="3233738" y="1148273"/>
                    <a:pt x="3220555" y="1143000"/>
                  </a:cubicBezTo>
                  <a:cubicBezTo>
                    <a:pt x="3201911" y="1135542"/>
                    <a:pt x="3180113" y="1135089"/>
                    <a:pt x="3163405" y="1123950"/>
                  </a:cubicBezTo>
                  <a:cubicBezTo>
                    <a:pt x="3144355" y="1111250"/>
                    <a:pt x="3122444" y="1102039"/>
                    <a:pt x="3106255" y="1085850"/>
                  </a:cubicBezTo>
                  <a:cubicBezTo>
                    <a:pt x="3070580" y="1050175"/>
                    <a:pt x="3090459" y="1061535"/>
                    <a:pt x="3049105" y="1047750"/>
                  </a:cubicBezTo>
                  <a:cubicBezTo>
                    <a:pt x="3020530" y="1050925"/>
                    <a:pt x="2991740" y="1052548"/>
                    <a:pt x="2963380" y="1057275"/>
                  </a:cubicBezTo>
                  <a:cubicBezTo>
                    <a:pt x="2953476" y="1058926"/>
                    <a:pt x="2942645" y="1060528"/>
                    <a:pt x="2934805" y="1066800"/>
                  </a:cubicBezTo>
                  <a:cubicBezTo>
                    <a:pt x="2881394" y="1109529"/>
                    <a:pt x="2960352" y="1087196"/>
                    <a:pt x="2877655" y="1123950"/>
                  </a:cubicBezTo>
                  <a:cubicBezTo>
                    <a:pt x="2862861" y="1130525"/>
                    <a:pt x="2845649" y="1129215"/>
                    <a:pt x="2830030" y="1133475"/>
                  </a:cubicBezTo>
                  <a:cubicBezTo>
                    <a:pt x="2810657" y="1138759"/>
                    <a:pt x="2792361" y="1147655"/>
                    <a:pt x="2772880" y="1152525"/>
                  </a:cubicBezTo>
                  <a:cubicBezTo>
                    <a:pt x="2760180" y="1155700"/>
                    <a:pt x="2746864" y="1157015"/>
                    <a:pt x="2734780" y="1162050"/>
                  </a:cubicBezTo>
                  <a:cubicBezTo>
                    <a:pt x="2585354" y="1224311"/>
                    <a:pt x="2732052" y="1181782"/>
                    <a:pt x="2582380" y="1219200"/>
                  </a:cubicBezTo>
                  <a:lnTo>
                    <a:pt x="2582380" y="1219200"/>
                  </a:lnTo>
                  <a:lnTo>
                    <a:pt x="2525230" y="1238250"/>
                  </a:lnTo>
                  <a:cubicBezTo>
                    <a:pt x="2439247" y="1213683"/>
                    <a:pt x="2480483" y="1226509"/>
                    <a:pt x="2401405" y="1200150"/>
                  </a:cubicBezTo>
                  <a:lnTo>
                    <a:pt x="2372830" y="1190625"/>
                  </a:lnTo>
                  <a:cubicBezTo>
                    <a:pt x="2328380" y="1193800"/>
                    <a:pt x="2283738" y="1194943"/>
                    <a:pt x="2239480" y="1200150"/>
                  </a:cubicBezTo>
                  <a:cubicBezTo>
                    <a:pt x="2208172" y="1203833"/>
                    <a:pt x="2209992" y="1214894"/>
                    <a:pt x="2182330" y="1228725"/>
                  </a:cubicBezTo>
                  <a:cubicBezTo>
                    <a:pt x="2173350" y="1233215"/>
                    <a:pt x="2163280" y="1235075"/>
                    <a:pt x="2153755" y="1238250"/>
                  </a:cubicBezTo>
                  <a:cubicBezTo>
                    <a:pt x="2125180" y="1235075"/>
                    <a:pt x="2096447" y="1233097"/>
                    <a:pt x="2068030" y="1228725"/>
                  </a:cubicBezTo>
                  <a:cubicBezTo>
                    <a:pt x="2055091" y="1226734"/>
                    <a:pt x="2043021" y="1219200"/>
                    <a:pt x="2029930" y="1219200"/>
                  </a:cubicBezTo>
                  <a:cubicBezTo>
                    <a:pt x="1960008" y="1219200"/>
                    <a:pt x="1890230" y="1225550"/>
                    <a:pt x="1820380" y="1228725"/>
                  </a:cubicBezTo>
                  <a:cubicBezTo>
                    <a:pt x="1801330" y="1235075"/>
                    <a:pt x="1782921" y="1243837"/>
                    <a:pt x="1763230" y="1247775"/>
                  </a:cubicBezTo>
                  <a:cubicBezTo>
                    <a:pt x="1702768" y="1259867"/>
                    <a:pt x="1731311" y="1253373"/>
                    <a:pt x="1677505" y="1266825"/>
                  </a:cubicBezTo>
                  <a:cubicBezTo>
                    <a:pt x="1566125" y="1341079"/>
                    <a:pt x="1662193" y="1284273"/>
                    <a:pt x="1591780" y="1314450"/>
                  </a:cubicBezTo>
                  <a:cubicBezTo>
                    <a:pt x="1578729" y="1320043"/>
                    <a:pt x="1567760" y="1331664"/>
                    <a:pt x="1553680" y="1333500"/>
                  </a:cubicBezTo>
                  <a:cubicBezTo>
                    <a:pt x="1493779" y="1341313"/>
                    <a:pt x="1433030" y="1339850"/>
                    <a:pt x="1372705" y="1343025"/>
                  </a:cubicBezTo>
                  <a:cubicBezTo>
                    <a:pt x="1344130" y="1339850"/>
                    <a:pt x="1313674" y="1344178"/>
                    <a:pt x="1286980" y="1333500"/>
                  </a:cubicBezTo>
                  <a:cubicBezTo>
                    <a:pt x="1277658" y="1329771"/>
                    <a:pt x="1283727" y="1312765"/>
                    <a:pt x="1277455" y="1304925"/>
                  </a:cubicBezTo>
                  <a:cubicBezTo>
                    <a:pt x="1261010" y="1284369"/>
                    <a:pt x="1233659" y="1282070"/>
                    <a:pt x="1210780" y="1276350"/>
                  </a:cubicBezTo>
                  <a:cubicBezTo>
                    <a:pt x="1156611" y="1222181"/>
                    <a:pt x="1208769" y="1265819"/>
                    <a:pt x="1153630" y="1238250"/>
                  </a:cubicBezTo>
                  <a:cubicBezTo>
                    <a:pt x="1079772" y="1201321"/>
                    <a:pt x="1168304" y="1233616"/>
                    <a:pt x="1096480" y="1209675"/>
                  </a:cubicBezTo>
                  <a:cubicBezTo>
                    <a:pt x="1053273" y="1144864"/>
                    <a:pt x="1074132" y="1162416"/>
                    <a:pt x="1020280" y="1123950"/>
                  </a:cubicBezTo>
                  <a:cubicBezTo>
                    <a:pt x="1010965" y="1117296"/>
                    <a:pt x="1002424" y="1108920"/>
                    <a:pt x="991705" y="1104900"/>
                  </a:cubicBezTo>
                  <a:cubicBezTo>
                    <a:pt x="976546" y="1099216"/>
                    <a:pt x="959699" y="1099635"/>
                    <a:pt x="944080" y="1095375"/>
                  </a:cubicBezTo>
                  <a:cubicBezTo>
                    <a:pt x="895163" y="1082034"/>
                    <a:pt x="884753" y="1074318"/>
                    <a:pt x="839305" y="1057275"/>
                  </a:cubicBezTo>
                  <a:cubicBezTo>
                    <a:pt x="829904" y="1053750"/>
                    <a:pt x="819710" y="1052240"/>
                    <a:pt x="810730" y="1047750"/>
                  </a:cubicBezTo>
                  <a:cubicBezTo>
                    <a:pt x="741997" y="1013384"/>
                    <a:pt x="827550" y="1043048"/>
                    <a:pt x="744055" y="1009650"/>
                  </a:cubicBezTo>
                  <a:cubicBezTo>
                    <a:pt x="725411" y="1002192"/>
                    <a:pt x="703613" y="1001739"/>
                    <a:pt x="686905" y="990600"/>
                  </a:cubicBezTo>
                  <a:cubicBezTo>
                    <a:pt x="677380" y="984250"/>
                    <a:pt x="668852" y="976059"/>
                    <a:pt x="658330" y="971550"/>
                  </a:cubicBezTo>
                  <a:cubicBezTo>
                    <a:pt x="646298" y="966393"/>
                    <a:pt x="632817" y="965621"/>
                    <a:pt x="620230" y="962025"/>
                  </a:cubicBezTo>
                  <a:cubicBezTo>
                    <a:pt x="610576" y="959267"/>
                    <a:pt x="601180" y="955675"/>
                    <a:pt x="591655" y="952500"/>
                  </a:cubicBezTo>
                  <a:cubicBezTo>
                    <a:pt x="535239" y="910188"/>
                    <a:pt x="566764" y="932731"/>
                    <a:pt x="496405" y="885825"/>
                  </a:cubicBezTo>
                  <a:cubicBezTo>
                    <a:pt x="486880" y="879475"/>
                    <a:pt x="475925" y="874870"/>
                    <a:pt x="467830" y="866775"/>
                  </a:cubicBezTo>
                  <a:cubicBezTo>
                    <a:pt x="458305" y="857250"/>
                    <a:pt x="449888" y="846470"/>
                    <a:pt x="439255" y="838200"/>
                  </a:cubicBezTo>
                  <a:cubicBezTo>
                    <a:pt x="421183" y="824144"/>
                    <a:pt x="398294" y="816289"/>
                    <a:pt x="382105" y="800100"/>
                  </a:cubicBezTo>
                  <a:cubicBezTo>
                    <a:pt x="372580" y="790575"/>
                    <a:pt x="364163" y="779795"/>
                    <a:pt x="353530" y="771525"/>
                  </a:cubicBezTo>
                  <a:cubicBezTo>
                    <a:pt x="335458" y="757469"/>
                    <a:pt x="312569" y="749614"/>
                    <a:pt x="296380" y="733425"/>
                  </a:cubicBezTo>
                  <a:cubicBezTo>
                    <a:pt x="286855" y="723900"/>
                    <a:pt x="278153" y="713474"/>
                    <a:pt x="267805" y="704850"/>
                  </a:cubicBezTo>
                  <a:cubicBezTo>
                    <a:pt x="247610" y="688021"/>
                    <a:pt x="224421" y="678395"/>
                    <a:pt x="201130" y="666750"/>
                  </a:cubicBezTo>
                  <a:cubicBezTo>
                    <a:pt x="194780" y="657225"/>
                    <a:pt x="187200" y="648414"/>
                    <a:pt x="182080" y="638175"/>
                  </a:cubicBezTo>
                  <a:cubicBezTo>
                    <a:pt x="177590" y="629195"/>
                    <a:pt x="178124" y="617954"/>
                    <a:pt x="172555" y="609600"/>
                  </a:cubicBezTo>
                  <a:cubicBezTo>
                    <a:pt x="165083" y="598392"/>
                    <a:pt x="152746" y="591252"/>
                    <a:pt x="143980" y="581025"/>
                  </a:cubicBezTo>
                  <a:cubicBezTo>
                    <a:pt x="70666" y="495491"/>
                    <a:pt x="157735" y="585255"/>
                    <a:pt x="86830" y="514350"/>
                  </a:cubicBezTo>
                  <a:cubicBezTo>
                    <a:pt x="83655" y="504825"/>
                    <a:pt x="77305" y="495815"/>
                    <a:pt x="77305" y="485775"/>
                  </a:cubicBezTo>
                  <a:cubicBezTo>
                    <a:pt x="77305" y="452248"/>
                    <a:pt x="86533" y="429517"/>
                    <a:pt x="96355" y="400050"/>
                  </a:cubicBezTo>
                  <a:cubicBezTo>
                    <a:pt x="82650" y="180778"/>
                    <a:pt x="129960" y="288354"/>
                    <a:pt x="58255" y="228600"/>
                  </a:cubicBezTo>
                  <a:cubicBezTo>
                    <a:pt x="47907" y="219976"/>
                    <a:pt x="39205" y="209550"/>
                    <a:pt x="29680" y="200025"/>
                  </a:cubicBezTo>
                  <a:cubicBezTo>
                    <a:pt x="6842" y="131512"/>
                    <a:pt x="34550" y="217071"/>
                    <a:pt x="10630" y="133350"/>
                  </a:cubicBezTo>
                  <a:cubicBezTo>
                    <a:pt x="7872" y="123696"/>
                    <a:pt x="1820" y="114790"/>
                    <a:pt x="1105" y="104775"/>
                  </a:cubicBezTo>
                  <a:cubicBezTo>
                    <a:pt x="-1383" y="69939"/>
                    <a:pt x="1105" y="34925"/>
                    <a:pt x="1105" y="0"/>
                  </a:cubicBezTo>
                </a:path>
              </a:pathLst>
            </a:custGeom>
            <a:noFill/>
            <a:ln w="28575">
              <a:solidFill>
                <a:srgbClr val="FF0000">
                  <a:alpha val="60000"/>
                </a:srgbClr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1" name="Freihandform 20"/>
            <p:cNvSpPr/>
            <p:nvPr/>
          </p:nvSpPr>
          <p:spPr>
            <a:xfrm>
              <a:off x="4676775" y="3914775"/>
              <a:ext cx="95250" cy="190500"/>
            </a:xfrm>
            <a:custGeom>
              <a:avLst/>
              <a:gdLst>
                <a:gd name="connsiteX0" fmla="*/ 0 w 95250"/>
                <a:gd name="connsiteY0" fmla="*/ 190500 h 190500"/>
                <a:gd name="connsiteX1" fmla="*/ 9525 w 95250"/>
                <a:gd name="connsiteY1" fmla="*/ 142875 h 190500"/>
                <a:gd name="connsiteX2" fmla="*/ 19050 w 95250"/>
                <a:gd name="connsiteY2" fmla="*/ 47625 h 190500"/>
                <a:gd name="connsiteX3" fmla="*/ 95250 w 95250"/>
                <a:gd name="connsiteY3" fmla="*/ 0 h 1905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95250" h="190500">
                  <a:moveTo>
                    <a:pt x="0" y="190500"/>
                  </a:moveTo>
                  <a:cubicBezTo>
                    <a:pt x="3175" y="174625"/>
                    <a:pt x="7385" y="158922"/>
                    <a:pt x="9525" y="142875"/>
                  </a:cubicBezTo>
                  <a:cubicBezTo>
                    <a:pt x="13742" y="111247"/>
                    <a:pt x="4780" y="76165"/>
                    <a:pt x="19050" y="47625"/>
                  </a:cubicBezTo>
                  <a:cubicBezTo>
                    <a:pt x="26056" y="33612"/>
                    <a:pt x="73102" y="11074"/>
                    <a:pt x="95250" y="0"/>
                  </a:cubicBezTo>
                </a:path>
              </a:pathLst>
            </a:cu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2" name="Ellipse 21"/>
            <p:cNvSpPr/>
            <p:nvPr/>
          </p:nvSpPr>
          <p:spPr>
            <a:xfrm>
              <a:off x="3886312" y="6208854"/>
              <a:ext cx="107577" cy="101600"/>
            </a:xfrm>
            <a:prstGeom prst="ellipse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3" name="Textfeld 22"/>
            <p:cNvSpPr txBox="1"/>
            <p:nvPr/>
          </p:nvSpPr>
          <p:spPr>
            <a:xfrm>
              <a:off x="3672189" y="5999291"/>
              <a:ext cx="9268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mberg (AS33)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Ellipse 23"/>
            <p:cNvSpPr/>
            <p:nvPr/>
          </p:nvSpPr>
          <p:spPr>
            <a:xfrm>
              <a:off x="1435463" y="6742857"/>
              <a:ext cx="107577" cy="101600"/>
            </a:xfrm>
            <a:prstGeom prst="ellipse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5" name="Textfeld 24"/>
            <p:cNvSpPr txBox="1"/>
            <p:nvPr/>
          </p:nvSpPr>
          <p:spPr>
            <a:xfrm>
              <a:off x="1622375" y="6599697"/>
              <a:ext cx="4700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K23)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6" name="Textfeld 25"/>
          <p:cNvSpPr txBox="1"/>
          <p:nvPr/>
        </p:nvSpPr>
        <p:spPr>
          <a:xfrm>
            <a:off x="963590" y="6372799"/>
            <a:ext cx="1003125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Figure S2: </a:t>
            </a:r>
            <a:r>
              <a:rPr lang="en-US" sz="1200" dirty="0" smtClean="0"/>
              <a:t>Map of central Europe with all TBEV isolation sites of TBEV strains used for full </a:t>
            </a:r>
            <a:r>
              <a:rPr lang="en-US" sz="1200" dirty="0"/>
              <a:t>g</a:t>
            </a:r>
            <a:r>
              <a:rPr lang="en-US" sz="1200" dirty="0" smtClean="0"/>
              <a:t>enome and E gene analysis (marked by red circles). Potential motorways supporting TBEV spread from Poland to Lower Saxony are highlighted by red dotted lines.</a:t>
            </a:r>
            <a:endParaRPr lang="en-US" sz="1200" dirty="0"/>
          </a:p>
        </p:txBody>
      </p:sp>
      <p:sp>
        <p:nvSpPr>
          <p:cNvPr id="28" name="Textfeld 27"/>
          <p:cNvSpPr txBox="1"/>
          <p:nvPr/>
        </p:nvSpPr>
        <p:spPr>
          <a:xfrm>
            <a:off x="9802163" y="2549685"/>
            <a:ext cx="64312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PL1971)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416026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18988" y="5964270"/>
            <a:ext cx="95711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Table S1</a:t>
            </a:r>
            <a:r>
              <a:rPr lang="en-US" sz="1200" dirty="0" smtClean="0"/>
              <a:t>: Case numbers in all German federal states in the years 2001-2019. TBE case numbers from Lower Saxony are marked in red.</a:t>
            </a:r>
          </a:p>
          <a:p>
            <a:r>
              <a:rPr lang="en-US" sz="1200" dirty="0" smtClean="0"/>
              <a:t>The table was created using </a:t>
            </a:r>
            <a:r>
              <a:rPr lang="en-US" sz="1200" dirty="0" smtClean="0">
                <a:hlinkClick r:id="rId2"/>
              </a:rPr>
              <a:t>Survstat@RKI2.0</a:t>
            </a:r>
            <a:r>
              <a:rPr lang="en-US" sz="1200" dirty="0"/>
              <a:t> (https://</a:t>
            </a:r>
            <a:r>
              <a:rPr lang="en-US" sz="1200" dirty="0" smtClean="0"/>
              <a:t>survstat.rki.de/Content/Query/Chart.aspx). </a:t>
            </a:r>
            <a:endParaRPr lang="en-US" sz="1200" dirty="0"/>
          </a:p>
        </p:txBody>
      </p:sp>
      <p:graphicFrame>
        <p:nvGraphicFramePr>
          <p:cNvPr id="4" name="Tabel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96599621"/>
              </p:ext>
            </p:extLst>
          </p:nvPr>
        </p:nvGraphicFramePr>
        <p:xfrm>
          <a:off x="90150" y="25763"/>
          <a:ext cx="12003112" cy="5548160"/>
        </p:xfrm>
        <a:graphic>
          <a:graphicData uri="http://schemas.openxmlformats.org/drawingml/2006/table">
            <a:tbl>
              <a:tblPr/>
              <a:tblGrid>
                <a:gridCol w="795574">
                  <a:extLst>
                    <a:ext uri="{9D8B030D-6E8A-4147-A177-3AD203B41FA5}">
                      <a16:colId xmlns:a16="http://schemas.microsoft.com/office/drawing/2014/main" xmlns="" val="524091595"/>
                    </a:ext>
                  </a:extLst>
                </a:gridCol>
                <a:gridCol w="1050465">
                  <a:extLst>
                    <a:ext uri="{9D8B030D-6E8A-4147-A177-3AD203B41FA5}">
                      <a16:colId xmlns:a16="http://schemas.microsoft.com/office/drawing/2014/main" xmlns="" val="1381574338"/>
                    </a:ext>
                  </a:extLst>
                </a:gridCol>
                <a:gridCol w="401650">
                  <a:extLst>
                    <a:ext uri="{9D8B030D-6E8A-4147-A177-3AD203B41FA5}">
                      <a16:colId xmlns:a16="http://schemas.microsoft.com/office/drawing/2014/main" xmlns="" val="4271795475"/>
                    </a:ext>
                  </a:extLst>
                </a:gridCol>
                <a:gridCol w="339857">
                  <a:extLst>
                    <a:ext uri="{9D8B030D-6E8A-4147-A177-3AD203B41FA5}">
                      <a16:colId xmlns:a16="http://schemas.microsoft.com/office/drawing/2014/main" xmlns="" val="2701657922"/>
                    </a:ext>
                  </a:extLst>
                </a:gridCol>
                <a:gridCol w="709448">
                  <a:extLst>
                    <a:ext uri="{9D8B030D-6E8A-4147-A177-3AD203B41FA5}">
                      <a16:colId xmlns:a16="http://schemas.microsoft.com/office/drawing/2014/main" xmlns="" val="701200292"/>
                    </a:ext>
                  </a:extLst>
                </a:gridCol>
                <a:gridCol w="502276">
                  <a:extLst>
                    <a:ext uri="{9D8B030D-6E8A-4147-A177-3AD203B41FA5}">
                      <a16:colId xmlns:a16="http://schemas.microsoft.com/office/drawing/2014/main" xmlns="" val="3483055416"/>
                    </a:ext>
                  </a:extLst>
                </a:gridCol>
                <a:gridCol w="540912">
                  <a:extLst>
                    <a:ext uri="{9D8B030D-6E8A-4147-A177-3AD203B41FA5}">
                      <a16:colId xmlns:a16="http://schemas.microsoft.com/office/drawing/2014/main" xmlns="" val="1216027814"/>
                    </a:ext>
                  </a:extLst>
                </a:gridCol>
                <a:gridCol w="437882">
                  <a:extLst>
                    <a:ext uri="{9D8B030D-6E8A-4147-A177-3AD203B41FA5}">
                      <a16:colId xmlns:a16="http://schemas.microsoft.com/office/drawing/2014/main" xmlns="" val="3679737034"/>
                    </a:ext>
                  </a:extLst>
                </a:gridCol>
                <a:gridCol w="1120507">
                  <a:extLst>
                    <a:ext uri="{9D8B030D-6E8A-4147-A177-3AD203B41FA5}">
                      <a16:colId xmlns:a16="http://schemas.microsoft.com/office/drawing/2014/main" xmlns="" val="131509845"/>
                    </a:ext>
                  </a:extLst>
                </a:gridCol>
                <a:gridCol w="710608">
                  <a:extLst>
                    <a:ext uri="{9D8B030D-6E8A-4147-A177-3AD203B41FA5}">
                      <a16:colId xmlns:a16="http://schemas.microsoft.com/office/drawing/2014/main" xmlns="" val="2565296425"/>
                    </a:ext>
                  </a:extLst>
                </a:gridCol>
                <a:gridCol w="1228118">
                  <a:extLst>
                    <a:ext uri="{9D8B030D-6E8A-4147-A177-3AD203B41FA5}">
                      <a16:colId xmlns:a16="http://schemas.microsoft.com/office/drawing/2014/main" xmlns="" val="2491664243"/>
                    </a:ext>
                  </a:extLst>
                </a:gridCol>
                <a:gridCol w="1073636">
                  <a:extLst>
                    <a:ext uri="{9D8B030D-6E8A-4147-A177-3AD203B41FA5}">
                      <a16:colId xmlns:a16="http://schemas.microsoft.com/office/drawing/2014/main" xmlns="" val="3378676678"/>
                    </a:ext>
                  </a:extLst>
                </a:gridCol>
                <a:gridCol w="463440">
                  <a:extLst>
                    <a:ext uri="{9D8B030D-6E8A-4147-A177-3AD203B41FA5}">
                      <a16:colId xmlns:a16="http://schemas.microsoft.com/office/drawing/2014/main" xmlns="" val="3088323680"/>
                    </a:ext>
                  </a:extLst>
                </a:gridCol>
                <a:gridCol w="393926">
                  <a:extLst>
                    <a:ext uri="{9D8B030D-6E8A-4147-A177-3AD203B41FA5}">
                      <a16:colId xmlns:a16="http://schemas.microsoft.com/office/drawing/2014/main" xmlns="" val="2766116675"/>
                    </a:ext>
                  </a:extLst>
                </a:gridCol>
                <a:gridCol w="751804">
                  <a:extLst>
                    <a:ext uri="{9D8B030D-6E8A-4147-A177-3AD203B41FA5}">
                      <a16:colId xmlns:a16="http://schemas.microsoft.com/office/drawing/2014/main" xmlns="" val="3860306512"/>
                    </a:ext>
                  </a:extLst>
                </a:gridCol>
                <a:gridCol w="978374">
                  <a:extLst>
                    <a:ext uri="{9D8B030D-6E8A-4147-A177-3AD203B41FA5}">
                      <a16:colId xmlns:a16="http://schemas.microsoft.com/office/drawing/2014/main" xmlns="" val="1747378936"/>
                    </a:ext>
                  </a:extLst>
                </a:gridCol>
                <a:gridCol w="504635">
                  <a:extLst>
                    <a:ext uri="{9D8B030D-6E8A-4147-A177-3AD203B41FA5}">
                      <a16:colId xmlns:a16="http://schemas.microsoft.com/office/drawing/2014/main" xmlns="" val="177660100"/>
                    </a:ext>
                  </a:extLst>
                </a:gridCol>
              </a:tblGrid>
              <a:tr h="464506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ar </a:t>
                      </a:r>
                      <a:r>
                        <a:rPr lang="de-DE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f</a:t>
                      </a: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de-DE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tification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te</a:t>
                      </a: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005644818"/>
                  </a:ext>
                </a:extLst>
              </a:tr>
              <a:tr h="251162"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den-Württemberg</a:t>
                      </a: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varia</a:t>
                      </a: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erlin</a:t>
                      </a: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andenburg</a:t>
                      </a: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emen</a:t>
                      </a: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mburg</a:t>
                      </a: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sse</a:t>
                      </a: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cklenburg-Vorpommern</a:t>
                      </a: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Lower</a:t>
                      </a:r>
                      <a:r>
                        <a:rPr lang="de-DE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de-DE" sz="10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Saxony</a:t>
                      </a:r>
                      <a:endParaRPr lang="de-DE" sz="10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th Rhine-</a:t>
                      </a:r>
                      <a:r>
                        <a:rPr lang="de-DE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estphalia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hineland</a:t>
                      </a: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Palatinate</a:t>
                      </a: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arland</a:t>
                      </a: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xony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xony</a:t>
                      </a: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Anhalt</a:t>
                      </a: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hleswig-Holstein</a:t>
                      </a: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uringia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38427445"/>
                  </a:ext>
                </a:extLst>
              </a:tr>
              <a:tr h="25116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01</a:t>
                      </a:r>
                    </a:p>
                  </a:txBody>
                  <a:tcPr marL="6776" marR="6776" marT="6776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5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797892787"/>
                  </a:ext>
                </a:extLst>
              </a:tr>
              <a:tr h="25116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02</a:t>
                      </a:r>
                    </a:p>
                  </a:txBody>
                  <a:tcPr marL="6776" marR="6776" marT="6776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5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27745103"/>
                  </a:ext>
                </a:extLst>
              </a:tr>
              <a:tr h="25116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03</a:t>
                      </a:r>
                    </a:p>
                  </a:txBody>
                  <a:tcPr marL="6776" marR="6776" marT="6776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7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6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91628183"/>
                  </a:ext>
                </a:extLst>
              </a:tr>
              <a:tr h="25116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04</a:t>
                      </a:r>
                    </a:p>
                  </a:txBody>
                  <a:tcPr marL="6776" marR="6776" marT="6776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0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388183968"/>
                  </a:ext>
                </a:extLst>
              </a:tr>
              <a:tr h="25116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05</a:t>
                      </a:r>
                    </a:p>
                  </a:txBody>
                  <a:tcPr marL="6776" marR="6776" marT="6776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5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098654774"/>
                  </a:ext>
                </a:extLst>
              </a:tr>
              <a:tr h="25116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06</a:t>
                      </a:r>
                    </a:p>
                  </a:txBody>
                  <a:tcPr marL="6776" marR="6776" marT="6776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8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73961066"/>
                  </a:ext>
                </a:extLst>
              </a:tr>
              <a:tr h="25116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07</a:t>
                      </a:r>
                    </a:p>
                  </a:txBody>
                  <a:tcPr marL="6776" marR="6776" marT="6776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0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98284029"/>
                  </a:ext>
                </a:extLst>
              </a:tr>
              <a:tr h="25116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08</a:t>
                      </a:r>
                    </a:p>
                  </a:txBody>
                  <a:tcPr marL="6776" marR="6776" marT="6776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0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8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39343147"/>
                  </a:ext>
                </a:extLst>
              </a:tr>
              <a:tr h="25116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09</a:t>
                      </a:r>
                    </a:p>
                  </a:txBody>
                  <a:tcPr marL="6776" marR="6776" marT="6776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5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34163845"/>
                  </a:ext>
                </a:extLst>
              </a:tr>
              <a:tr h="25116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0</a:t>
                      </a:r>
                    </a:p>
                  </a:txBody>
                  <a:tcPr marL="6776" marR="6776" marT="6776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8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4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51408236"/>
                  </a:ext>
                </a:extLst>
              </a:tr>
              <a:tr h="25116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1</a:t>
                      </a:r>
                    </a:p>
                  </a:txBody>
                  <a:tcPr marL="6776" marR="6776" marT="6776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8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975842528"/>
                  </a:ext>
                </a:extLst>
              </a:tr>
              <a:tr h="25116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2</a:t>
                      </a:r>
                    </a:p>
                  </a:txBody>
                  <a:tcPr marL="6776" marR="6776" marT="6776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0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666881178"/>
                  </a:ext>
                </a:extLst>
              </a:tr>
              <a:tr h="25116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3</a:t>
                      </a:r>
                    </a:p>
                  </a:txBody>
                  <a:tcPr marL="6776" marR="6776" marT="6776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7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6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185632970"/>
                  </a:ext>
                </a:extLst>
              </a:tr>
              <a:tr h="25116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4</a:t>
                      </a:r>
                    </a:p>
                  </a:txBody>
                  <a:tcPr marL="6776" marR="6776" marT="6776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99098345"/>
                  </a:ext>
                </a:extLst>
              </a:tr>
              <a:tr h="25116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5</a:t>
                      </a:r>
                    </a:p>
                  </a:txBody>
                  <a:tcPr marL="6776" marR="6776" marT="6776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6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48327964"/>
                  </a:ext>
                </a:extLst>
              </a:tr>
              <a:tr h="25116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6</a:t>
                      </a:r>
                    </a:p>
                  </a:txBody>
                  <a:tcPr marL="6776" marR="6776" marT="6776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0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9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057789465"/>
                  </a:ext>
                </a:extLst>
              </a:tr>
              <a:tr h="25116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7</a:t>
                      </a:r>
                    </a:p>
                  </a:txBody>
                  <a:tcPr marL="6776" marR="6776" marT="6776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4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58979777"/>
                  </a:ext>
                </a:extLst>
              </a:tr>
              <a:tr h="25116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8</a:t>
                      </a:r>
                    </a:p>
                  </a:txBody>
                  <a:tcPr marL="6776" marR="6776" marT="6776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4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159234599"/>
                  </a:ext>
                </a:extLst>
              </a:tr>
              <a:tr h="25116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</a:t>
                      </a:r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umbers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76" marR="6776" marT="6776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89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8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6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61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6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</a:t>
                      </a:r>
                    </a:p>
                  </a:txBody>
                  <a:tcPr marL="6776" marR="6776" marT="677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65094834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018106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62</Words>
  <Application>Microsoft Office PowerPoint</Application>
  <PresentationFormat>Widescreen</PresentationFormat>
  <Paragraphs>30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PowerPoint Presentation</vt:lpstr>
      <vt:lpstr>PowerPoint Presentation</vt:lpstr>
      <vt:lpstr>PowerPoint Presentation</vt:lpstr>
    </vt:vector>
  </TitlesOfParts>
  <Company>TiHo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ecker, Stefanie</dc:creator>
  <cp:lastModifiedBy>MDPI</cp:lastModifiedBy>
  <cp:revision>22</cp:revision>
  <dcterms:created xsi:type="dcterms:W3CDTF">2019-04-24T09:02:25Z</dcterms:created>
  <dcterms:modified xsi:type="dcterms:W3CDTF">2019-05-21T07:47:36Z</dcterms:modified>
</cp:coreProperties>
</file>